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  <p:sldMasterId id="2147483672" r:id="rId2"/>
  </p:sldMasterIdLst>
  <p:notesMasterIdLst>
    <p:notesMasterId r:id="rId6"/>
  </p:notesMasterIdLst>
  <p:sldIdLst>
    <p:sldId id="256" r:id="rId3"/>
    <p:sldId id="265" r:id="rId4"/>
    <p:sldId id="267" r:id="rId5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EEC9054-8E62-4D03-ABBD-78E16A26253F}" v="50" dt="2022-06-02T14:36:52.97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030"/>
    <p:restoredTop sz="66017" autoAdjust="0"/>
  </p:normalViewPr>
  <p:slideViewPr>
    <p:cSldViewPr snapToGrid="0" snapToObjects="1">
      <p:cViewPr varScale="1">
        <p:scale>
          <a:sx n="72" d="100"/>
          <a:sy n="72" d="100"/>
        </p:scale>
        <p:origin x="2400" y="72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relle Liu" userId="9c120045ac198691" providerId="LiveId" clId="{0EEC9054-8E62-4D03-ABBD-78E16A26253F}"/>
    <pc:docChg chg="undo redo custSel addSld delSld modSld">
      <pc:chgData name="Shirelle Liu" userId="9c120045ac198691" providerId="LiveId" clId="{0EEC9054-8E62-4D03-ABBD-78E16A26253F}" dt="2022-06-07T14:57:30.665" v="1456" actId="20577"/>
      <pc:docMkLst>
        <pc:docMk/>
      </pc:docMkLst>
      <pc:sldChg chg="modNotesTx">
        <pc:chgData name="Shirelle Liu" userId="9c120045ac198691" providerId="LiveId" clId="{0EEC9054-8E62-4D03-ABBD-78E16A26253F}" dt="2022-06-07T14:57:19.683" v="1446" actId="20577"/>
        <pc:sldMkLst>
          <pc:docMk/>
          <pc:sldMk cId="1102509393" sldId="256"/>
        </pc:sldMkLst>
      </pc:sldChg>
      <pc:sldChg chg="del">
        <pc:chgData name="Shirelle Liu" userId="9c120045ac198691" providerId="LiveId" clId="{0EEC9054-8E62-4D03-ABBD-78E16A26253F}" dt="2022-06-01T18:33:35.814" v="5" actId="47"/>
        <pc:sldMkLst>
          <pc:docMk/>
          <pc:sldMk cId="738320340" sldId="257"/>
        </pc:sldMkLst>
      </pc:sldChg>
      <pc:sldChg chg="new del">
        <pc:chgData name="Shirelle Liu" userId="9c120045ac198691" providerId="LiveId" clId="{0EEC9054-8E62-4D03-ABBD-78E16A26253F}" dt="2022-06-01T18:33:37.935" v="6" actId="47"/>
        <pc:sldMkLst>
          <pc:docMk/>
          <pc:sldMk cId="223539906" sldId="258"/>
        </pc:sldMkLst>
      </pc:sldChg>
      <pc:sldChg chg="addSp delSp modSp add mod modNotesTx">
        <pc:chgData name="Shirelle Liu" userId="9c120045ac198691" providerId="LiveId" clId="{0EEC9054-8E62-4D03-ABBD-78E16A26253F}" dt="2022-06-07T14:57:25.952" v="1451" actId="20577"/>
        <pc:sldMkLst>
          <pc:docMk/>
          <pc:sldMk cId="888492466" sldId="265"/>
        </pc:sldMkLst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5" creationId="{A19BD6A9-01A6-4C69-A401-4AF223AAFA4A}"/>
          </ac:spMkLst>
        </pc:spChg>
        <pc:spChg chg="add mod">
          <ac:chgData name="Shirelle Liu" userId="9c120045ac198691" providerId="LiveId" clId="{0EEC9054-8E62-4D03-ABBD-78E16A26253F}" dt="2022-06-01T19:17:50.510" v="573" actId="2711"/>
          <ac:spMkLst>
            <pc:docMk/>
            <pc:sldMk cId="888492466" sldId="265"/>
            <ac:spMk id="7" creationId="{718C20A9-3790-47DA-859D-3F67546EF933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13" creationId="{D8860C2D-A2DF-48CF-BB78-61756720671F}"/>
          </ac:spMkLst>
        </pc:spChg>
        <pc:spChg chg="del mod">
          <ac:chgData name="Shirelle Liu" userId="9c120045ac198691" providerId="LiveId" clId="{0EEC9054-8E62-4D03-ABBD-78E16A26253F}" dt="2022-06-01T18:34:32.266" v="12" actId="478"/>
          <ac:spMkLst>
            <pc:docMk/>
            <pc:sldMk cId="888492466" sldId="265"/>
            <ac:spMk id="15" creationId="{D94E38C5-7175-40BF-A9EB-FD8E6FCBA40E}"/>
          </ac:spMkLst>
        </pc:spChg>
        <pc:spChg chg="del">
          <ac:chgData name="Shirelle Liu" userId="9c120045ac198691" providerId="LiveId" clId="{0EEC9054-8E62-4D03-ABBD-78E16A26253F}" dt="2022-06-01T18:34:01.712" v="9" actId="478"/>
          <ac:spMkLst>
            <pc:docMk/>
            <pc:sldMk cId="888492466" sldId="265"/>
            <ac:spMk id="16" creationId="{2B1C75C1-7BC0-4D65-B732-665F2818B17E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17" creationId="{05CC37A0-24BA-4499-B912-A4CDDD83E0BA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18" creationId="{48BE2E8A-EDA4-4B5F-9918-E0BBAB4E58B3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19" creationId="{3DF7C57E-59FD-4EB9-8112-568917DA60F8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0" creationId="{4BAC4277-0DA2-45B9-A048-8C31D58ECADC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1" creationId="{2758508A-EDAA-40B9-B99C-C6B59D8D32AA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2" creationId="{131DEA9A-2353-45F1-BCC9-ACC7638D4F11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3" creationId="{D054BA0A-2D11-4A71-917F-BBEB44CDF290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4" creationId="{8EB08545-2BC9-4109-A742-22D5F4040E52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5" creationId="{69707908-0A34-4865-95CD-B2A02E03952E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6" creationId="{9980859F-3F5D-4164-AF95-0D0D87C146D8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7" creationId="{416742F1-60F0-417B-AB9B-010564097C42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8" creationId="{CB7D2D0E-0826-42A4-A6C0-D8E28DC3FE54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29" creationId="{E3B3DBBC-D7B5-40F6-BFE7-27C5A1ACF952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30" creationId="{042E2FA0-DD62-4C89-B626-EBFB3BC65BEF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31" creationId="{B5D0432B-CAA1-4D7F-AA1F-4FE8A39E4558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32" creationId="{8533E214-80FC-42E2-A9CB-9E926C666B6E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33" creationId="{5464ED37-18FD-4819-8F01-A0C9471E2CA3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34" creationId="{207B7BFE-11AB-4ED6-A094-3908C71EC566}"/>
          </ac:spMkLst>
        </pc:spChg>
        <pc:spChg chg="add mod">
          <ac:chgData name="Shirelle Liu" userId="9c120045ac198691" providerId="LiveId" clId="{0EEC9054-8E62-4D03-ABBD-78E16A26253F}" dt="2022-06-01T18:58:32.683" v="324" actId="164"/>
          <ac:spMkLst>
            <pc:docMk/>
            <pc:sldMk cId="888492466" sldId="265"/>
            <ac:spMk id="35" creationId="{E7B8A0B1-00D6-43AA-A9CD-F627A710451F}"/>
          </ac:spMkLst>
        </pc:spChg>
        <pc:spChg chg="add mod">
          <ac:chgData name="Shirelle Liu" userId="9c120045ac198691" providerId="LiveId" clId="{0EEC9054-8E62-4D03-ABBD-78E16A26253F}" dt="2022-06-01T19:17:42.498" v="572" actId="2711"/>
          <ac:spMkLst>
            <pc:docMk/>
            <pc:sldMk cId="888492466" sldId="265"/>
            <ac:spMk id="36" creationId="{B653E171-017B-4759-A9F8-85A06E6D9BF9}"/>
          </ac:spMkLst>
        </pc:spChg>
        <pc:spChg chg="add mod">
          <ac:chgData name="Shirelle Liu" userId="9c120045ac198691" providerId="LiveId" clId="{0EEC9054-8E62-4D03-ABBD-78E16A26253F}" dt="2022-06-01T19:17:42.498" v="572" actId="2711"/>
          <ac:spMkLst>
            <pc:docMk/>
            <pc:sldMk cId="888492466" sldId="265"/>
            <ac:spMk id="37" creationId="{7A1E2336-9383-4B0E-B4BA-B7C51E1B576F}"/>
          </ac:spMkLst>
        </pc:spChg>
        <pc:spChg chg="add mod">
          <ac:chgData name="Shirelle Liu" userId="9c120045ac198691" providerId="LiveId" clId="{0EEC9054-8E62-4D03-ABBD-78E16A26253F}" dt="2022-06-01T19:17:42.498" v="572" actId="2711"/>
          <ac:spMkLst>
            <pc:docMk/>
            <pc:sldMk cId="888492466" sldId="265"/>
            <ac:spMk id="38" creationId="{FF7B3306-3232-4BA0-923D-24FC15E4699B}"/>
          </ac:spMkLst>
        </pc:spChg>
        <pc:spChg chg="add mod">
          <ac:chgData name="Shirelle Liu" userId="9c120045ac198691" providerId="LiveId" clId="{0EEC9054-8E62-4D03-ABBD-78E16A26253F}" dt="2022-06-01T19:17:42.498" v="572" actId="2711"/>
          <ac:spMkLst>
            <pc:docMk/>
            <pc:sldMk cId="888492466" sldId="265"/>
            <ac:spMk id="39" creationId="{B82A6090-EEE0-454E-A155-DCE2DFE0CF9C}"/>
          </ac:spMkLst>
        </pc:spChg>
        <pc:spChg chg="add mod">
          <ac:chgData name="Shirelle Liu" userId="9c120045ac198691" providerId="LiveId" clId="{0EEC9054-8E62-4D03-ABBD-78E16A26253F}" dt="2022-06-01T19:17:42.498" v="572" actId="2711"/>
          <ac:spMkLst>
            <pc:docMk/>
            <pc:sldMk cId="888492466" sldId="265"/>
            <ac:spMk id="40" creationId="{B42DD186-C2E5-4BF5-9CC4-E9B2BFF292AD}"/>
          </ac:spMkLst>
        </pc:spChg>
        <pc:spChg chg="mod">
          <ac:chgData name="Shirelle Liu" userId="9c120045ac198691" providerId="LiveId" clId="{0EEC9054-8E62-4D03-ABBD-78E16A26253F}" dt="2022-06-01T18:58:06.940" v="323" actId="1035"/>
          <ac:spMkLst>
            <pc:docMk/>
            <pc:sldMk cId="888492466" sldId="265"/>
            <ac:spMk id="42" creationId="{5217ECE9-61D6-4BBE-B665-37B15265480B}"/>
          </ac:spMkLst>
        </pc:spChg>
        <pc:spChg chg="mod">
          <ac:chgData name="Shirelle Liu" userId="9c120045ac198691" providerId="LiveId" clId="{0EEC9054-8E62-4D03-ABBD-78E16A26253F}" dt="2022-06-01T18:57:58.516" v="314" actId="1036"/>
          <ac:spMkLst>
            <pc:docMk/>
            <pc:sldMk cId="888492466" sldId="265"/>
            <ac:spMk id="43" creationId="{1B55C0E4-185A-4439-A7EF-65CB3E7867CF}"/>
          </ac:spMkLst>
        </pc:spChg>
        <pc:spChg chg="mod">
          <ac:chgData name="Shirelle Liu" userId="9c120045ac198691" providerId="LiveId" clId="{0EEC9054-8E62-4D03-ABBD-78E16A26253F}" dt="2022-06-01T18:57:51.498" v="309" actId="1036"/>
          <ac:spMkLst>
            <pc:docMk/>
            <pc:sldMk cId="888492466" sldId="265"/>
            <ac:spMk id="44" creationId="{C661F41A-6E6B-4358-A625-17AC90ED3898}"/>
          </ac:spMkLst>
        </pc:spChg>
        <pc:spChg chg="mod">
          <ac:chgData name="Shirelle Liu" userId="9c120045ac198691" providerId="LiveId" clId="{0EEC9054-8E62-4D03-ABBD-78E16A26253F}" dt="2022-06-01T18:57:45.125" v="306" actId="1035"/>
          <ac:spMkLst>
            <pc:docMk/>
            <pc:sldMk cId="888492466" sldId="265"/>
            <ac:spMk id="45" creationId="{4CBBAF8B-4B90-4A8D-BCA4-09B267BD3528}"/>
          </ac:spMkLst>
        </pc:spChg>
        <pc:spChg chg="mod">
          <ac:chgData name="Shirelle Liu" userId="9c120045ac198691" providerId="LiveId" clId="{0EEC9054-8E62-4D03-ABBD-78E16A26253F}" dt="2022-06-01T18:57:23.352" v="302"/>
          <ac:spMkLst>
            <pc:docMk/>
            <pc:sldMk cId="888492466" sldId="265"/>
            <ac:spMk id="46" creationId="{F18B05B8-C1AA-4A81-92EA-D12C7970116B}"/>
          </ac:spMkLst>
        </pc:spChg>
        <pc:spChg chg="mod">
          <ac:chgData name="Shirelle Liu" userId="9c120045ac198691" providerId="LiveId" clId="{0EEC9054-8E62-4D03-ABBD-78E16A26253F}" dt="2022-06-01T18:57:40.132" v="305" actId="20577"/>
          <ac:spMkLst>
            <pc:docMk/>
            <pc:sldMk cId="888492466" sldId="265"/>
            <ac:spMk id="47" creationId="{673B5879-B0DD-4E60-9CF8-0C06AD7D68DD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49" creationId="{AC06C364-24F8-4E99-B8A0-C7C2B5AA0367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50" creationId="{B5AA20FE-1607-49BD-A777-ECFA954A37DF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51" creationId="{A89E945F-5419-4C85-B61E-749B62D93572}"/>
          </ac:spMkLst>
        </pc:spChg>
        <pc:spChg chg="mod">
          <ac:chgData name="Shirelle Liu" userId="9c120045ac198691" providerId="LiveId" clId="{0EEC9054-8E62-4D03-ABBD-78E16A26253F}" dt="2022-06-01T18:59:13.426" v="419" actId="1037"/>
          <ac:spMkLst>
            <pc:docMk/>
            <pc:sldMk cId="888492466" sldId="265"/>
            <ac:spMk id="52" creationId="{FF5507BA-AA7C-46F7-9031-E7C8E73413F3}"/>
          </ac:spMkLst>
        </pc:spChg>
        <pc:spChg chg="mod">
          <ac:chgData name="Shirelle Liu" userId="9c120045ac198691" providerId="LiveId" clId="{0EEC9054-8E62-4D03-ABBD-78E16A26253F}" dt="2022-06-01T18:59:23.099" v="420" actId="1037"/>
          <ac:spMkLst>
            <pc:docMk/>
            <pc:sldMk cId="888492466" sldId="265"/>
            <ac:spMk id="53" creationId="{38094C68-61D7-42FB-B709-7A94DE117376}"/>
          </ac:spMkLst>
        </pc:spChg>
        <pc:spChg chg="mod">
          <ac:chgData name="Shirelle Liu" userId="9c120045ac198691" providerId="LiveId" clId="{0EEC9054-8E62-4D03-ABBD-78E16A26253F}" dt="2022-06-01T19:00:30.951" v="421" actId="1037"/>
          <ac:spMkLst>
            <pc:docMk/>
            <pc:sldMk cId="888492466" sldId="265"/>
            <ac:spMk id="54" creationId="{DA23836A-78B1-4F7E-BB0E-71EBF8F5BF44}"/>
          </ac:spMkLst>
        </pc:spChg>
        <pc:spChg chg="mod">
          <ac:chgData name="Shirelle Liu" userId="9c120045ac198691" providerId="LiveId" clId="{0EEC9054-8E62-4D03-ABBD-78E16A26253F}" dt="2022-06-01T19:00:41.533" v="423" actId="1037"/>
          <ac:spMkLst>
            <pc:docMk/>
            <pc:sldMk cId="888492466" sldId="265"/>
            <ac:spMk id="55" creationId="{F69C6F41-76B4-4C3D-8F75-66392F0355DF}"/>
          </ac:spMkLst>
        </pc:spChg>
        <pc:spChg chg="mod">
          <ac:chgData name="Shirelle Liu" userId="9c120045ac198691" providerId="LiveId" clId="{0EEC9054-8E62-4D03-ABBD-78E16A26253F}" dt="2022-06-01T19:01:35.588" v="428" actId="1037"/>
          <ac:spMkLst>
            <pc:docMk/>
            <pc:sldMk cId="888492466" sldId="265"/>
            <ac:spMk id="56" creationId="{94C18C23-6039-4BAA-8F5A-E0E96FAA6E5F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57" creationId="{DB1852E7-1394-40ED-B374-4C92475D822C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58" creationId="{35927BDD-B777-4001-99CC-0CDE0398AF10}"/>
          </ac:spMkLst>
        </pc:spChg>
        <pc:spChg chg="mod">
          <ac:chgData name="Shirelle Liu" userId="9c120045ac198691" providerId="LiveId" clId="{0EEC9054-8E62-4D03-ABBD-78E16A26253F}" dt="2022-06-01T19:01:43.635" v="429" actId="1038"/>
          <ac:spMkLst>
            <pc:docMk/>
            <pc:sldMk cId="888492466" sldId="265"/>
            <ac:spMk id="59" creationId="{F636DA12-4295-4A89-8308-9B1929E7DACA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60" creationId="{30056F77-4002-468E-AED9-7B5F388405DC}"/>
          </ac:spMkLst>
        </pc:spChg>
        <pc:spChg chg="mod">
          <ac:chgData name="Shirelle Liu" userId="9c120045ac198691" providerId="LiveId" clId="{0EEC9054-8E62-4D03-ABBD-78E16A26253F}" dt="2022-06-01T19:02:01.204" v="433" actId="1038"/>
          <ac:spMkLst>
            <pc:docMk/>
            <pc:sldMk cId="888492466" sldId="265"/>
            <ac:spMk id="61" creationId="{B8CE9695-7126-4DD0-B742-57BF31515D1F}"/>
          </ac:spMkLst>
        </pc:spChg>
        <pc:spChg chg="mod">
          <ac:chgData name="Shirelle Liu" userId="9c120045ac198691" providerId="LiveId" clId="{0EEC9054-8E62-4D03-ABBD-78E16A26253F}" dt="2022-06-01T19:02:11.954" v="437" actId="1037"/>
          <ac:spMkLst>
            <pc:docMk/>
            <pc:sldMk cId="888492466" sldId="265"/>
            <ac:spMk id="62" creationId="{B5DCDDE0-D0BB-457D-9E87-6AFC1B4D5D87}"/>
          </ac:spMkLst>
        </pc:spChg>
        <pc:spChg chg="mod">
          <ac:chgData name="Shirelle Liu" userId="9c120045ac198691" providerId="LiveId" clId="{0EEC9054-8E62-4D03-ABBD-78E16A26253F}" dt="2022-06-01T19:02:18.372" v="439" actId="1038"/>
          <ac:spMkLst>
            <pc:docMk/>
            <pc:sldMk cId="888492466" sldId="265"/>
            <ac:spMk id="63" creationId="{7CC552AE-9565-4C30-9A77-708D2B418711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64" creationId="{FFF78704-BC53-4B42-B8BB-43BA8DC7607F}"/>
          </ac:spMkLst>
        </pc:spChg>
        <pc:spChg chg="mod">
          <ac:chgData name="Shirelle Liu" userId="9c120045ac198691" providerId="LiveId" clId="{0EEC9054-8E62-4D03-ABBD-78E16A26253F}" dt="2022-06-01T18:58:34.503" v="325"/>
          <ac:spMkLst>
            <pc:docMk/>
            <pc:sldMk cId="888492466" sldId="265"/>
            <ac:spMk id="65" creationId="{8BFBEA95-F326-471A-B4DC-A6D3AAE4D388}"/>
          </ac:spMkLst>
        </pc:spChg>
        <pc:spChg chg="mod">
          <ac:chgData name="Shirelle Liu" userId="9c120045ac198691" providerId="LiveId" clId="{0EEC9054-8E62-4D03-ABBD-78E16A26253F}" dt="2022-06-01T19:04:07.262" v="453" actId="1038"/>
          <ac:spMkLst>
            <pc:docMk/>
            <pc:sldMk cId="888492466" sldId="265"/>
            <ac:spMk id="66" creationId="{00AFCEFA-4052-46D9-897E-1ED8C0697F88}"/>
          </ac:spMkLst>
        </pc:spChg>
        <pc:spChg chg="mod">
          <ac:chgData name="Shirelle Liu" userId="9c120045ac198691" providerId="LiveId" clId="{0EEC9054-8E62-4D03-ABBD-78E16A26253F}" dt="2022-06-01T19:03:59.646" v="452" actId="1038"/>
          <ac:spMkLst>
            <pc:docMk/>
            <pc:sldMk cId="888492466" sldId="265"/>
            <ac:spMk id="67" creationId="{7E83963D-457D-40EA-A2F9-F3B08F24A768}"/>
          </ac:spMkLst>
        </pc:spChg>
        <pc:spChg chg="mod">
          <ac:chgData name="Shirelle Liu" userId="9c120045ac198691" providerId="LiveId" clId="{0EEC9054-8E62-4D03-ABBD-78E16A26253F}" dt="2022-06-01T19:03:33.624" v="451" actId="1038"/>
          <ac:spMkLst>
            <pc:docMk/>
            <pc:sldMk cId="888492466" sldId="265"/>
            <ac:spMk id="68" creationId="{6C2BD47C-6D20-4660-88A5-529CC336E2C1}"/>
          </ac:spMkLst>
        </pc:spChg>
        <pc:spChg chg="mod">
          <ac:chgData name="Shirelle Liu" userId="9c120045ac198691" providerId="LiveId" clId="{0EEC9054-8E62-4D03-ABBD-78E16A26253F}" dt="2022-06-01T19:02:43.157" v="444" actId="1038"/>
          <ac:spMkLst>
            <pc:docMk/>
            <pc:sldMk cId="888492466" sldId="265"/>
            <ac:spMk id="69" creationId="{BED66A0A-D6A3-4C87-B6A2-1AA9B951B418}"/>
          </ac:spMkLst>
        </pc:spChg>
        <pc:spChg chg="mod">
          <ac:chgData name="Shirelle Liu" userId="9c120045ac198691" providerId="LiveId" clId="{0EEC9054-8E62-4D03-ABBD-78E16A26253F}" dt="2022-06-01T19:04:46.626" v="454"/>
          <ac:spMkLst>
            <pc:docMk/>
            <pc:sldMk cId="888492466" sldId="265"/>
            <ac:spMk id="71" creationId="{15614C39-2A1E-49A3-9152-70C06D87944C}"/>
          </ac:spMkLst>
        </pc:spChg>
        <pc:spChg chg="mod">
          <ac:chgData name="Shirelle Liu" userId="9c120045ac198691" providerId="LiveId" clId="{0EEC9054-8E62-4D03-ABBD-78E16A26253F}" dt="2022-06-01T19:04:46.626" v="454"/>
          <ac:spMkLst>
            <pc:docMk/>
            <pc:sldMk cId="888492466" sldId="265"/>
            <ac:spMk id="72" creationId="{77C03DB6-06FF-466F-BB10-258AD1816287}"/>
          </ac:spMkLst>
        </pc:spChg>
        <pc:spChg chg="mod">
          <ac:chgData name="Shirelle Liu" userId="9c120045ac198691" providerId="LiveId" clId="{0EEC9054-8E62-4D03-ABBD-78E16A26253F}" dt="2022-06-01T19:04:46.626" v="454"/>
          <ac:spMkLst>
            <pc:docMk/>
            <pc:sldMk cId="888492466" sldId="265"/>
            <ac:spMk id="73" creationId="{E1AC65DD-80C4-43B9-A5B5-E9299E9FEC5C}"/>
          </ac:spMkLst>
        </pc:spChg>
        <pc:spChg chg="mod">
          <ac:chgData name="Shirelle Liu" userId="9c120045ac198691" providerId="LiveId" clId="{0EEC9054-8E62-4D03-ABBD-78E16A26253F}" dt="2022-06-01T19:04:46.626" v="454"/>
          <ac:spMkLst>
            <pc:docMk/>
            <pc:sldMk cId="888492466" sldId="265"/>
            <ac:spMk id="74" creationId="{3DB80C0B-E31D-4E7A-8295-FC4065550635}"/>
          </ac:spMkLst>
        </pc:spChg>
        <pc:spChg chg="mod">
          <ac:chgData name="Shirelle Liu" userId="9c120045ac198691" providerId="LiveId" clId="{0EEC9054-8E62-4D03-ABBD-78E16A26253F}" dt="2022-06-01T19:04:46.626" v="454"/>
          <ac:spMkLst>
            <pc:docMk/>
            <pc:sldMk cId="888492466" sldId="265"/>
            <ac:spMk id="75" creationId="{002338C9-A5B6-404C-872F-BA844D1CDBC9}"/>
          </ac:spMkLst>
        </pc:spChg>
        <pc:spChg chg="mod">
          <ac:chgData name="Shirelle Liu" userId="9c120045ac198691" providerId="LiveId" clId="{0EEC9054-8E62-4D03-ABBD-78E16A26253F}" dt="2022-06-01T19:08:42.393" v="504" actId="20577"/>
          <ac:spMkLst>
            <pc:docMk/>
            <pc:sldMk cId="888492466" sldId="265"/>
            <ac:spMk id="76" creationId="{075553E3-0C3B-4E0E-9447-0300D2643994}"/>
          </ac:spMkLst>
        </pc:spChg>
        <pc:spChg chg="mod">
          <ac:chgData name="Shirelle Liu" userId="9c120045ac198691" providerId="LiveId" clId="{0EEC9054-8E62-4D03-ABBD-78E16A26253F}" dt="2022-06-01T19:09:48.422" v="510" actId="1038"/>
          <ac:spMkLst>
            <pc:docMk/>
            <pc:sldMk cId="888492466" sldId="265"/>
            <ac:spMk id="78" creationId="{A172B684-258C-433F-BE95-4E4A7A011608}"/>
          </ac:spMkLst>
        </pc:spChg>
        <pc:spChg chg="mod">
          <ac:chgData name="Shirelle Liu" userId="9c120045ac198691" providerId="LiveId" clId="{0EEC9054-8E62-4D03-ABBD-78E16A26253F}" dt="2022-06-01T19:09:56.796" v="511" actId="1038"/>
          <ac:spMkLst>
            <pc:docMk/>
            <pc:sldMk cId="888492466" sldId="265"/>
            <ac:spMk id="79" creationId="{FF52EE68-7C98-4735-A57B-09CC4DB34732}"/>
          </ac:spMkLst>
        </pc:spChg>
        <pc:spChg chg="mod">
          <ac:chgData name="Shirelle Liu" userId="9c120045ac198691" providerId="LiveId" clId="{0EEC9054-8E62-4D03-ABBD-78E16A26253F}" dt="2022-06-01T19:10:10.972" v="513" actId="1038"/>
          <ac:spMkLst>
            <pc:docMk/>
            <pc:sldMk cId="888492466" sldId="265"/>
            <ac:spMk id="80" creationId="{54199ED2-251C-4499-88EF-DE7E2F100F1B}"/>
          </ac:spMkLst>
        </pc:spChg>
        <pc:spChg chg="mod">
          <ac:chgData name="Shirelle Liu" userId="9c120045ac198691" providerId="LiveId" clId="{0EEC9054-8E62-4D03-ABBD-78E16A26253F}" dt="2022-06-01T19:10:23.636" v="514" actId="1038"/>
          <ac:spMkLst>
            <pc:docMk/>
            <pc:sldMk cId="888492466" sldId="265"/>
            <ac:spMk id="81" creationId="{D4B0CF29-980A-4C3A-804E-D9C89FC3FA16}"/>
          </ac:spMkLst>
        </pc:spChg>
        <pc:spChg chg="mod">
          <ac:chgData name="Shirelle Liu" userId="9c120045ac198691" providerId="LiveId" clId="{0EEC9054-8E62-4D03-ABBD-78E16A26253F}" dt="2022-06-01T19:10:31.553" v="515" actId="1038"/>
          <ac:spMkLst>
            <pc:docMk/>
            <pc:sldMk cId="888492466" sldId="265"/>
            <ac:spMk id="82" creationId="{25A4C1CB-5887-4F3B-8FEC-C5196B64EE04}"/>
          </ac:spMkLst>
        </pc:spChg>
        <pc:spChg chg="mod">
          <ac:chgData name="Shirelle Liu" userId="9c120045ac198691" providerId="LiveId" clId="{0EEC9054-8E62-4D03-ABBD-78E16A26253F}" dt="2022-06-01T19:10:48.249" v="518" actId="1037"/>
          <ac:spMkLst>
            <pc:docMk/>
            <pc:sldMk cId="888492466" sldId="265"/>
            <ac:spMk id="83" creationId="{F769E657-AFBB-4B8F-89BB-03F189DB3C03}"/>
          </ac:spMkLst>
        </pc:spChg>
        <pc:spChg chg="mod">
          <ac:chgData name="Shirelle Liu" userId="9c120045ac198691" providerId="LiveId" clId="{0EEC9054-8E62-4D03-ABBD-78E16A26253F}" dt="2022-06-01T19:10:54.269" v="519" actId="1038"/>
          <ac:spMkLst>
            <pc:docMk/>
            <pc:sldMk cId="888492466" sldId="265"/>
            <ac:spMk id="84" creationId="{6FE33F0B-BCAF-49CF-B0C5-83283733B558}"/>
          </ac:spMkLst>
        </pc:spChg>
        <pc:spChg chg="mod">
          <ac:chgData name="Shirelle Liu" userId="9c120045ac198691" providerId="LiveId" clId="{0EEC9054-8E62-4D03-ABBD-78E16A26253F}" dt="2022-06-01T19:11:01.624" v="521" actId="1038"/>
          <ac:spMkLst>
            <pc:docMk/>
            <pc:sldMk cId="888492466" sldId="265"/>
            <ac:spMk id="85" creationId="{4380E5BE-FD8B-4609-8AC4-06AA5277D896}"/>
          </ac:spMkLst>
        </pc:spChg>
        <pc:spChg chg="mod">
          <ac:chgData name="Shirelle Liu" userId="9c120045ac198691" providerId="LiveId" clId="{0EEC9054-8E62-4D03-ABBD-78E16A26253F}" dt="2022-06-01T19:11:17.736" v="524" actId="1037"/>
          <ac:spMkLst>
            <pc:docMk/>
            <pc:sldMk cId="888492466" sldId="265"/>
            <ac:spMk id="86" creationId="{B7555BCA-3DEE-45E5-A590-9692ED96E33A}"/>
          </ac:spMkLst>
        </pc:spChg>
        <pc:spChg chg="mod">
          <ac:chgData name="Shirelle Liu" userId="9c120045ac198691" providerId="LiveId" clId="{0EEC9054-8E62-4D03-ABBD-78E16A26253F}" dt="2022-06-01T19:08:56.177" v="505"/>
          <ac:spMkLst>
            <pc:docMk/>
            <pc:sldMk cId="888492466" sldId="265"/>
            <ac:spMk id="87" creationId="{62A313BB-B49C-41EE-A6AC-6D966575C510}"/>
          </ac:spMkLst>
        </pc:spChg>
        <pc:spChg chg="mod">
          <ac:chgData name="Shirelle Liu" userId="9c120045ac198691" providerId="LiveId" clId="{0EEC9054-8E62-4D03-ABBD-78E16A26253F}" dt="2022-06-01T19:12:07.336" v="531" actId="1038"/>
          <ac:spMkLst>
            <pc:docMk/>
            <pc:sldMk cId="888492466" sldId="265"/>
            <ac:spMk id="88" creationId="{E58FCA5C-3A08-4B4A-B099-8B14BE0D9BFB}"/>
          </ac:spMkLst>
        </pc:spChg>
        <pc:spChg chg="mod">
          <ac:chgData name="Shirelle Liu" userId="9c120045ac198691" providerId="LiveId" clId="{0EEC9054-8E62-4D03-ABBD-78E16A26253F}" dt="2022-06-01T19:12:00.867" v="530" actId="1038"/>
          <ac:spMkLst>
            <pc:docMk/>
            <pc:sldMk cId="888492466" sldId="265"/>
            <ac:spMk id="89" creationId="{3384E1F1-E9BA-4319-80C6-3E837AF476F4}"/>
          </ac:spMkLst>
        </pc:spChg>
        <pc:spChg chg="mod">
          <ac:chgData name="Shirelle Liu" userId="9c120045ac198691" providerId="LiveId" clId="{0EEC9054-8E62-4D03-ABBD-78E16A26253F}" dt="2022-06-01T19:11:53.340" v="529" actId="1037"/>
          <ac:spMkLst>
            <pc:docMk/>
            <pc:sldMk cId="888492466" sldId="265"/>
            <ac:spMk id="90" creationId="{C1E19951-A9A4-4DFC-A655-11F225729500}"/>
          </ac:spMkLst>
        </pc:spChg>
        <pc:spChg chg="mod">
          <ac:chgData name="Shirelle Liu" userId="9c120045ac198691" providerId="LiveId" clId="{0EEC9054-8E62-4D03-ABBD-78E16A26253F}" dt="2022-06-01T19:08:56.177" v="505"/>
          <ac:spMkLst>
            <pc:docMk/>
            <pc:sldMk cId="888492466" sldId="265"/>
            <ac:spMk id="91" creationId="{101E4F21-5DCF-419C-9AB0-8BD18006AC60}"/>
          </ac:spMkLst>
        </pc:spChg>
        <pc:spChg chg="mod">
          <ac:chgData name="Shirelle Liu" userId="9c120045ac198691" providerId="LiveId" clId="{0EEC9054-8E62-4D03-ABBD-78E16A26253F}" dt="2022-06-01T19:08:56.177" v="505"/>
          <ac:spMkLst>
            <pc:docMk/>
            <pc:sldMk cId="888492466" sldId="265"/>
            <ac:spMk id="92" creationId="{1E53AF53-448A-44FB-92E3-464A0B07EAFB}"/>
          </ac:spMkLst>
        </pc:spChg>
        <pc:spChg chg="mod">
          <ac:chgData name="Shirelle Liu" userId="9c120045ac198691" providerId="LiveId" clId="{0EEC9054-8E62-4D03-ABBD-78E16A26253F}" dt="2022-06-01T19:11:41.914" v="527" actId="1038"/>
          <ac:spMkLst>
            <pc:docMk/>
            <pc:sldMk cId="888492466" sldId="265"/>
            <ac:spMk id="93" creationId="{972B8FBC-7F66-4D20-B6EA-3B897FEDA72B}"/>
          </ac:spMkLst>
        </pc:spChg>
        <pc:spChg chg="mod">
          <ac:chgData name="Shirelle Liu" userId="9c120045ac198691" providerId="LiveId" clId="{0EEC9054-8E62-4D03-ABBD-78E16A26253F}" dt="2022-06-01T19:11:35.499" v="526" actId="1038"/>
          <ac:spMkLst>
            <pc:docMk/>
            <pc:sldMk cId="888492466" sldId="265"/>
            <ac:spMk id="94" creationId="{65268CFD-EEA7-4A8B-9FD8-B9760153CB4B}"/>
          </ac:spMkLst>
        </pc:spChg>
        <pc:spChg chg="mod">
          <ac:chgData name="Shirelle Liu" userId="9c120045ac198691" providerId="LiveId" clId="{0EEC9054-8E62-4D03-ABBD-78E16A26253F}" dt="2022-06-01T19:08:56.177" v="505"/>
          <ac:spMkLst>
            <pc:docMk/>
            <pc:sldMk cId="888492466" sldId="265"/>
            <ac:spMk id="95" creationId="{9967A5E6-1654-4859-BFAF-1F8A7713A648}"/>
          </ac:spMkLst>
        </pc:spChg>
        <pc:spChg chg="mod">
          <ac:chgData name="Shirelle Liu" userId="9c120045ac198691" providerId="LiveId" clId="{0EEC9054-8E62-4D03-ABBD-78E16A26253F}" dt="2022-06-01T19:08:56.177" v="505"/>
          <ac:spMkLst>
            <pc:docMk/>
            <pc:sldMk cId="888492466" sldId="265"/>
            <ac:spMk id="96" creationId="{395204AA-5E3C-4476-AD1B-5CA7B6E23D17}"/>
          </ac:spMkLst>
        </pc:spChg>
        <pc:spChg chg="mod">
          <ac:chgData name="Shirelle Liu" userId="9c120045ac198691" providerId="LiveId" clId="{0EEC9054-8E62-4D03-ABBD-78E16A26253F}" dt="2022-06-01T19:08:56.177" v="505"/>
          <ac:spMkLst>
            <pc:docMk/>
            <pc:sldMk cId="888492466" sldId="265"/>
            <ac:spMk id="97" creationId="{1BC46CC8-8AC7-4DBF-B27F-41C8FDF43A72}"/>
          </ac:spMkLst>
        </pc:spChg>
        <pc:spChg chg="mod">
          <ac:chgData name="Shirelle Liu" userId="9c120045ac198691" providerId="LiveId" clId="{0EEC9054-8E62-4D03-ABBD-78E16A26253F}" dt="2022-06-01T19:11:26.694" v="525" actId="1038"/>
          <ac:spMkLst>
            <pc:docMk/>
            <pc:sldMk cId="888492466" sldId="265"/>
            <ac:spMk id="98" creationId="{8C4F2E39-91CA-485C-904F-0E230AC3C281}"/>
          </ac:spMkLst>
        </pc:spChg>
        <pc:spChg chg="add mod">
          <ac:chgData name="Shirelle Liu" userId="9c120045ac198691" providerId="LiveId" clId="{0EEC9054-8E62-4D03-ABBD-78E16A26253F}" dt="2022-06-01T19:17:15.699" v="548" actId="1076"/>
          <ac:spMkLst>
            <pc:docMk/>
            <pc:sldMk cId="888492466" sldId="265"/>
            <ac:spMk id="99" creationId="{E2E0C1A2-545F-4873-A835-0664E0CAD3AC}"/>
          </ac:spMkLst>
        </pc:spChg>
        <pc:spChg chg="add mod">
          <ac:chgData name="Shirelle Liu" userId="9c120045ac198691" providerId="LiveId" clId="{0EEC9054-8E62-4D03-ABBD-78E16A26253F}" dt="2022-06-01T19:19:36.118" v="793" actId="1035"/>
          <ac:spMkLst>
            <pc:docMk/>
            <pc:sldMk cId="888492466" sldId="265"/>
            <ac:spMk id="100" creationId="{D77EAC4B-7052-4D6F-9736-19959742CD11}"/>
          </ac:spMkLst>
        </pc:spChg>
        <pc:spChg chg="add mod">
          <ac:chgData name="Shirelle Liu" userId="9c120045ac198691" providerId="LiveId" clId="{0EEC9054-8E62-4D03-ABBD-78E16A26253F}" dt="2022-06-01T19:19:18.950" v="791" actId="1035"/>
          <ac:spMkLst>
            <pc:docMk/>
            <pc:sldMk cId="888492466" sldId="265"/>
            <ac:spMk id="101" creationId="{27B70E8D-260B-4BE4-862F-39F1A849297D}"/>
          </ac:spMkLst>
        </pc:spChg>
        <pc:grpChg chg="add del mod">
          <ac:chgData name="Shirelle Liu" userId="9c120045ac198691" providerId="LiveId" clId="{0EEC9054-8E62-4D03-ABBD-78E16A26253F}" dt="2022-06-01T18:34:37.461" v="13" actId="165"/>
          <ac:grpSpMkLst>
            <pc:docMk/>
            <pc:sldMk cId="888492466" sldId="265"/>
            <ac:grpSpMk id="2" creationId="{1B7133B0-2C2D-4D2D-98EA-BB52B8840283}"/>
          </ac:grpSpMkLst>
        </pc:grpChg>
        <pc:grpChg chg="add del mod">
          <ac:chgData name="Shirelle Liu" userId="9c120045ac198691" providerId="LiveId" clId="{0EEC9054-8E62-4D03-ABBD-78E16A26253F}" dt="2022-06-01T18:36:21.913" v="36" actId="165"/>
          <ac:grpSpMkLst>
            <pc:docMk/>
            <pc:sldMk cId="888492466" sldId="265"/>
            <ac:grpSpMk id="3" creationId="{D863EDB6-6222-46D4-92C8-7779D4FD6A55}"/>
          </ac:grpSpMkLst>
        </pc:grpChg>
        <pc:grpChg chg="add mod">
          <ac:chgData name="Shirelle Liu" userId="9c120045ac198691" providerId="LiveId" clId="{0EEC9054-8E62-4D03-ABBD-78E16A26253F}" dt="2022-06-01T18:57:20.974" v="301" actId="164"/>
          <ac:grpSpMkLst>
            <pc:docMk/>
            <pc:sldMk cId="888492466" sldId="265"/>
            <ac:grpSpMk id="9" creationId="{82B78D83-0EDA-40C0-BFCA-02FC90CE345C}"/>
          </ac:grpSpMkLst>
        </pc:grpChg>
        <pc:grpChg chg="add mod">
          <ac:chgData name="Shirelle Liu" userId="9c120045ac198691" providerId="LiveId" clId="{0EEC9054-8E62-4D03-ABBD-78E16A26253F}" dt="2022-06-01T18:58:32.683" v="324" actId="164"/>
          <ac:grpSpMkLst>
            <pc:docMk/>
            <pc:sldMk cId="888492466" sldId="265"/>
            <ac:grpSpMk id="11" creationId="{6FC6F9EA-33EF-45D0-A82D-3550C7EA9C6B}"/>
          </ac:grpSpMkLst>
        </pc:grpChg>
        <pc:grpChg chg="add mod">
          <ac:chgData name="Shirelle Liu" userId="9c120045ac198691" providerId="LiveId" clId="{0EEC9054-8E62-4D03-ABBD-78E16A26253F}" dt="2022-06-01T18:57:34.587" v="303" actId="1076"/>
          <ac:grpSpMkLst>
            <pc:docMk/>
            <pc:sldMk cId="888492466" sldId="265"/>
            <ac:grpSpMk id="41" creationId="{E3D0D9C5-6FB5-47B4-9C48-17339A708872}"/>
          </ac:grpSpMkLst>
        </pc:grpChg>
        <pc:grpChg chg="add mod">
          <ac:chgData name="Shirelle Liu" userId="9c120045ac198691" providerId="LiveId" clId="{0EEC9054-8E62-4D03-ABBD-78E16A26253F}" dt="2022-06-01T19:09:11.397" v="507" actId="1036"/>
          <ac:grpSpMkLst>
            <pc:docMk/>
            <pc:sldMk cId="888492466" sldId="265"/>
            <ac:grpSpMk id="48" creationId="{AD71EC1F-F97C-4A3D-BF5B-006BF07AE50C}"/>
          </ac:grpSpMkLst>
        </pc:grpChg>
        <pc:grpChg chg="add mod">
          <ac:chgData name="Shirelle Liu" userId="9c120045ac198691" providerId="LiveId" clId="{0EEC9054-8E62-4D03-ABBD-78E16A26253F}" dt="2022-06-01T19:08:33.692" v="502" actId="1036"/>
          <ac:grpSpMkLst>
            <pc:docMk/>
            <pc:sldMk cId="888492466" sldId="265"/>
            <ac:grpSpMk id="70" creationId="{B1F8BD26-91D3-4385-B156-B7E0FDB160AE}"/>
          </ac:grpSpMkLst>
        </pc:grpChg>
        <pc:grpChg chg="add mod">
          <ac:chgData name="Shirelle Liu" userId="9c120045ac198691" providerId="LiveId" clId="{0EEC9054-8E62-4D03-ABBD-78E16A26253F}" dt="2022-06-01T19:09:25.316" v="509" actId="1035"/>
          <ac:grpSpMkLst>
            <pc:docMk/>
            <pc:sldMk cId="888492466" sldId="265"/>
            <ac:grpSpMk id="77" creationId="{A8586CEE-FD31-4320-9F42-DBC19621E631}"/>
          </ac:grpSpMkLst>
        </pc:grpChg>
        <pc:picChg chg="mod topLvl modCrop">
          <ac:chgData name="Shirelle Liu" userId="9c120045ac198691" providerId="LiveId" clId="{0EEC9054-8E62-4D03-ABBD-78E16A26253F}" dt="2022-06-01T18:38:11.903" v="46" actId="732"/>
          <ac:picMkLst>
            <pc:docMk/>
            <pc:sldMk cId="888492466" sldId="265"/>
            <ac:picMk id="4" creationId="{B7581E32-D1C1-4B53-A0C4-8E1373EAF351}"/>
          </ac:picMkLst>
        </pc:picChg>
        <pc:picChg chg="mod topLvl modCrop">
          <ac:chgData name="Shirelle Liu" userId="9c120045ac198691" providerId="LiveId" clId="{0EEC9054-8E62-4D03-ABBD-78E16A26253F}" dt="2022-06-01T18:57:09.250" v="300" actId="1076"/>
          <ac:picMkLst>
            <pc:docMk/>
            <pc:sldMk cId="888492466" sldId="265"/>
            <ac:picMk id="6" creationId="{B89E8DAB-352D-4936-8BC5-0996AA8D7E77}"/>
          </ac:picMkLst>
        </pc:picChg>
        <pc:picChg chg="mod topLvl modCrop">
          <ac:chgData name="Shirelle Liu" userId="9c120045ac198691" providerId="LiveId" clId="{0EEC9054-8E62-4D03-ABBD-78E16A26253F}" dt="2022-06-01T19:08:16.431" v="500" actId="1076"/>
          <ac:picMkLst>
            <pc:docMk/>
            <pc:sldMk cId="888492466" sldId="265"/>
            <ac:picMk id="8" creationId="{A868B542-A543-4173-BA62-C187A04BCF52}"/>
          </ac:picMkLst>
        </pc:picChg>
        <pc:picChg chg="del">
          <ac:chgData name="Shirelle Liu" userId="9c120045ac198691" providerId="LiveId" clId="{0EEC9054-8E62-4D03-ABBD-78E16A26253F}" dt="2022-06-01T18:33:59.539" v="8" actId="478"/>
          <ac:picMkLst>
            <pc:docMk/>
            <pc:sldMk cId="888492466" sldId="265"/>
            <ac:picMk id="10" creationId="{0D698A10-354B-4301-8AD6-7CEE110B10D9}"/>
          </ac:picMkLst>
        </pc:picChg>
        <pc:picChg chg="del">
          <ac:chgData name="Shirelle Liu" userId="9c120045ac198691" providerId="LiveId" clId="{0EEC9054-8E62-4D03-ABBD-78E16A26253F}" dt="2022-06-01T18:33:57.025" v="7" actId="478"/>
          <ac:picMkLst>
            <pc:docMk/>
            <pc:sldMk cId="888492466" sldId="265"/>
            <ac:picMk id="12" creationId="{9ABE3617-9337-447A-A39A-1D43F93A88F8}"/>
          </ac:picMkLst>
        </pc:picChg>
        <pc:picChg chg="del">
          <ac:chgData name="Shirelle Liu" userId="9c120045ac198691" providerId="LiveId" clId="{0EEC9054-8E62-4D03-ABBD-78E16A26253F}" dt="2022-06-01T18:33:57.025" v="7" actId="478"/>
          <ac:picMkLst>
            <pc:docMk/>
            <pc:sldMk cId="888492466" sldId="265"/>
            <ac:picMk id="14" creationId="{AA935128-6037-44A7-9E4B-0C5A07EE41F9}"/>
          </ac:picMkLst>
        </pc:picChg>
      </pc:sldChg>
      <pc:sldChg chg="addSp delSp modSp add del mod">
        <pc:chgData name="Shirelle Liu" userId="9c120045ac198691" providerId="LiveId" clId="{0EEC9054-8E62-4D03-ABBD-78E16A26253F}" dt="2022-06-02T14:36:43.689" v="1097" actId="47"/>
        <pc:sldMkLst>
          <pc:docMk/>
          <pc:sldMk cId="2160879395" sldId="266"/>
        </pc:sldMkLst>
        <pc:spChg chg="del">
          <ac:chgData name="Shirelle Liu" userId="9c120045ac198691" providerId="LiveId" clId="{0EEC9054-8E62-4D03-ABBD-78E16A26253F}" dt="2022-06-01T19:19:53.300" v="795" actId="478"/>
          <ac:spMkLst>
            <pc:docMk/>
            <pc:sldMk cId="2160879395" sldId="266"/>
            <ac:spMk id="15" creationId="{D94E38C5-7175-40BF-A9EB-FD8E6FCBA40E}"/>
          </ac:spMkLst>
        </pc:spChg>
        <pc:spChg chg="del">
          <ac:chgData name="Shirelle Liu" userId="9c120045ac198691" providerId="LiveId" clId="{0EEC9054-8E62-4D03-ABBD-78E16A26253F}" dt="2022-06-01T19:19:57.283" v="796" actId="478"/>
          <ac:spMkLst>
            <pc:docMk/>
            <pc:sldMk cId="2160879395" sldId="266"/>
            <ac:spMk id="16" creationId="{2B1C75C1-7BC0-4D65-B732-665F2818B17E}"/>
          </ac:spMkLst>
        </pc:spChg>
        <pc:picChg chg="del">
          <ac:chgData name="Shirelle Liu" userId="9c120045ac198691" providerId="LiveId" clId="{0EEC9054-8E62-4D03-ABBD-78E16A26253F}" dt="2022-06-01T19:19:53.300" v="795" actId="478"/>
          <ac:picMkLst>
            <pc:docMk/>
            <pc:sldMk cId="2160879395" sldId="266"/>
            <ac:picMk id="4" creationId="{B7581E32-D1C1-4B53-A0C4-8E1373EAF351}"/>
          </ac:picMkLst>
        </pc:picChg>
        <pc:picChg chg="del">
          <ac:chgData name="Shirelle Liu" userId="9c120045ac198691" providerId="LiveId" clId="{0EEC9054-8E62-4D03-ABBD-78E16A26253F}" dt="2022-06-01T19:19:53.300" v="795" actId="478"/>
          <ac:picMkLst>
            <pc:docMk/>
            <pc:sldMk cId="2160879395" sldId="266"/>
            <ac:picMk id="6" creationId="{B89E8DAB-352D-4936-8BC5-0996AA8D7E77}"/>
          </ac:picMkLst>
        </pc:picChg>
        <pc:picChg chg="del">
          <ac:chgData name="Shirelle Liu" userId="9c120045ac198691" providerId="LiveId" clId="{0EEC9054-8E62-4D03-ABBD-78E16A26253F}" dt="2022-06-01T19:19:53.300" v="795" actId="478"/>
          <ac:picMkLst>
            <pc:docMk/>
            <pc:sldMk cId="2160879395" sldId="266"/>
            <ac:picMk id="8" creationId="{A868B542-A543-4173-BA62-C187A04BCF52}"/>
          </ac:picMkLst>
        </pc:picChg>
        <pc:picChg chg="del mod">
          <ac:chgData name="Shirelle Liu" userId="9c120045ac198691" providerId="LiveId" clId="{0EEC9054-8E62-4D03-ABBD-78E16A26253F}" dt="2022-06-01T19:42:50.857" v="947" actId="478"/>
          <ac:picMkLst>
            <pc:docMk/>
            <pc:sldMk cId="2160879395" sldId="266"/>
            <ac:picMk id="10" creationId="{0D698A10-354B-4301-8AD6-7CEE110B10D9}"/>
          </ac:picMkLst>
        </pc:picChg>
        <pc:picChg chg="add mod">
          <ac:chgData name="Shirelle Liu" userId="9c120045ac198691" providerId="LiveId" clId="{0EEC9054-8E62-4D03-ABBD-78E16A26253F}" dt="2022-06-01T19:43:01.668" v="948"/>
          <ac:picMkLst>
            <pc:docMk/>
            <pc:sldMk cId="2160879395" sldId="266"/>
            <ac:picMk id="11" creationId="{8D538B31-5C56-4142-BAC9-A4BE3D2EC0C2}"/>
          </ac:picMkLst>
        </pc:picChg>
        <pc:picChg chg="mod modCrop">
          <ac:chgData name="Shirelle Liu" userId="9c120045ac198691" providerId="LiveId" clId="{0EEC9054-8E62-4D03-ABBD-78E16A26253F}" dt="2022-06-01T19:44:47.624" v="963" actId="14100"/>
          <ac:picMkLst>
            <pc:docMk/>
            <pc:sldMk cId="2160879395" sldId="266"/>
            <ac:picMk id="12" creationId="{9ABE3617-9337-447A-A39A-1D43F93A88F8}"/>
          </ac:picMkLst>
        </pc:picChg>
        <pc:picChg chg="mod modCrop">
          <ac:chgData name="Shirelle Liu" userId="9c120045ac198691" providerId="LiveId" clId="{0EEC9054-8E62-4D03-ABBD-78E16A26253F}" dt="2022-06-02T14:35:53.254" v="1038" actId="732"/>
          <ac:picMkLst>
            <pc:docMk/>
            <pc:sldMk cId="2160879395" sldId="266"/>
            <ac:picMk id="14" creationId="{AA935128-6037-44A7-9E4B-0C5A07EE41F9}"/>
          </ac:picMkLst>
        </pc:picChg>
      </pc:sldChg>
      <pc:sldChg chg="addSp delSp modSp add mod modNotesTx">
        <pc:chgData name="Shirelle Liu" userId="9c120045ac198691" providerId="LiveId" clId="{0EEC9054-8E62-4D03-ABBD-78E16A26253F}" dt="2022-06-07T14:57:30.665" v="1456" actId="20577"/>
        <pc:sldMkLst>
          <pc:docMk/>
          <pc:sldMk cId="1493675132" sldId="267"/>
        </pc:sldMkLst>
        <pc:spChg chg="mod">
          <ac:chgData name="Shirelle Liu" userId="9c120045ac198691" providerId="LiveId" clId="{0EEC9054-8E62-4D03-ABBD-78E16A26253F}" dt="2022-06-01T19:29:38.579" v="870" actId="1076"/>
          <ac:spMkLst>
            <pc:docMk/>
            <pc:sldMk cId="1493675132" sldId="267"/>
            <ac:spMk id="7" creationId="{718C20A9-3790-47DA-859D-3F67546EF933}"/>
          </ac:spMkLst>
        </pc:spChg>
        <pc:spChg chg="mod">
          <ac:chgData name="Shirelle Liu" userId="9c120045ac198691" providerId="LiveId" clId="{0EEC9054-8E62-4D03-ABBD-78E16A26253F}" dt="2022-06-01T19:42:38.002" v="946" actId="1038"/>
          <ac:spMkLst>
            <pc:docMk/>
            <pc:sldMk cId="1493675132" sldId="267"/>
            <ac:spMk id="13" creationId="{D8860C2D-A2DF-48CF-BB78-61756720671F}"/>
          </ac:spMkLst>
        </pc:spChg>
        <pc:spChg chg="mod">
          <ac:chgData name="Shirelle Liu" userId="9c120045ac198691" providerId="LiveId" clId="{0EEC9054-8E62-4D03-ABBD-78E16A26253F}" dt="2022-06-01T19:42:30.427" v="945" actId="1038"/>
          <ac:spMkLst>
            <pc:docMk/>
            <pc:sldMk cId="1493675132" sldId="267"/>
            <ac:spMk id="17" creationId="{05CC37A0-24BA-4499-B912-A4CDDD83E0BA}"/>
          </ac:spMkLst>
        </pc:spChg>
        <pc:spChg chg="mod">
          <ac:chgData name="Shirelle Liu" userId="9c120045ac198691" providerId="LiveId" clId="{0EEC9054-8E62-4D03-ABBD-78E16A26253F}" dt="2022-06-01T19:42:22.222" v="943" actId="1038"/>
          <ac:spMkLst>
            <pc:docMk/>
            <pc:sldMk cId="1493675132" sldId="267"/>
            <ac:spMk id="18" creationId="{48BE2E8A-EDA4-4B5F-9918-E0BBAB4E58B3}"/>
          </ac:spMkLst>
        </pc:spChg>
        <pc:spChg chg="mod">
          <ac:chgData name="Shirelle Liu" userId="9c120045ac198691" providerId="LiveId" clId="{0EEC9054-8E62-4D03-ABBD-78E16A26253F}" dt="2022-06-01T19:42:10.723" v="941" actId="1038"/>
          <ac:spMkLst>
            <pc:docMk/>
            <pc:sldMk cId="1493675132" sldId="267"/>
            <ac:spMk id="19" creationId="{3DF7C57E-59FD-4EB9-8112-568917DA60F8}"/>
          </ac:spMkLst>
        </pc:spChg>
        <pc:spChg chg="mod">
          <ac:chgData name="Shirelle Liu" userId="9c120045ac198691" providerId="LiveId" clId="{0EEC9054-8E62-4D03-ABBD-78E16A26253F}" dt="2022-06-01T19:41:58.800" v="940" actId="1038"/>
          <ac:spMkLst>
            <pc:docMk/>
            <pc:sldMk cId="1493675132" sldId="267"/>
            <ac:spMk id="20" creationId="{4BAC4277-0DA2-45B9-A048-8C31D58ECADC}"/>
          </ac:spMkLst>
        </pc:spChg>
        <pc:spChg chg="mod">
          <ac:chgData name="Shirelle Liu" userId="9c120045ac198691" providerId="LiveId" clId="{0EEC9054-8E62-4D03-ABBD-78E16A26253F}" dt="2022-06-01T19:41:42.632" v="938" actId="1037"/>
          <ac:spMkLst>
            <pc:docMk/>
            <pc:sldMk cId="1493675132" sldId="267"/>
            <ac:spMk id="21" creationId="{2758508A-EDAA-40B9-B99C-C6B59D8D32AA}"/>
          </ac:spMkLst>
        </pc:spChg>
        <pc:spChg chg="mod">
          <ac:chgData name="Shirelle Liu" userId="9c120045ac198691" providerId="LiveId" clId="{0EEC9054-8E62-4D03-ABBD-78E16A26253F}" dt="2022-06-01T19:41:15.650" v="930" actId="1037"/>
          <ac:spMkLst>
            <pc:docMk/>
            <pc:sldMk cId="1493675132" sldId="267"/>
            <ac:spMk id="22" creationId="{131DEA9A-2353-45F1-BCC9-ACC7638D4F11}"/>
          </ac:spMkLst>
        </pc:spChg>
        <pc:spChg chg="mod">
          <ac:chgData name="Shirelle Liu" userId="9c120045ac198691" providerId="LiveId" clId="{0EEC9054-8E62-4D03-ABBD-78E16A26253F}" dt="2022-06-01T19:41:06.370" v="929" actId="1037"/>
          <ac:spMkLst>
            <pc:docMk/>
            <pc:sldMk cId="1493675132" sldId="267"/>
            <ac:spMk id="23" creationId="{D054BA0A-2D11-4A71-917F-BBEB44CDF290}"/>
          </ac:spMkLst>
        </pc:spChg>
        <pc:spChg chg="mod">
          <ac:chgData name="Shirelle Liu" userId="9c120045ac198691" providerId="LiveId" clId="{0EEC9054-8E62-4D03-ABBD-78E16A26253F}" dt="2022-06-01T19:35:15.537" v="915" actId="1037"/>
          <ac:spMkLst>
            <pc:docMk/>
            <pc:sldMk cId="1493675132" sldId="267"/>
            <ac:spMk id="24" creationId="{8EB08545-2BC9-4109-A742-22D5F4040E52}"/>
          </ac:spMkLst>
        </pc:spChg>
        <pc:spChg chg="mod">
          <ac:chgData name="Shirelle Liu" userId="9c120045ac198691" providerId="LiveId" clId="{0EEC9054-8E62-4D03-ABBD-78E16A26253F}" dt="2022-06-01T19:34:38.913" v="908" actId="1038"/>
          <ac:spMkLst>
            <pc:docMk/>
            <pc:sldMk cId="1493675132" sldId="267"/>
            <ac:spMk id="25" creationId="{69707908-0A34-4865-95CD-B2A02E03952E}"/>
          </ac:spMkLst>
        </pc:spChg>
        <pc:spChg chg="mod">
          <ac:chgData name="Shirelle Liu" userId="9c120045ac198691" providerId="LiveId" clId="{0EEC9054-8E62-4D03-ABBD-78E16A26253F}" dt="2022-06-01T19:34:54.299" v="909" actId="1038"/>
          <ac:spMkLst>
            <pc:docMk/>
            <pc:sldMk cId="1493675132" sldId="267"/>
            <ac:spMk id="26" creationId="{9980859F-3F5D-4164-AF95-0D0D87C146D8}"/>
          </ac:spMkLst>
        </pc:spChg>
        <pc:spChg chg="mod">
          <ac:chgData name="Shirelle Liu" userId="9c120045ac198691" providerId="LiveId" clId="{0EEC9054-8E62-4D03-ABBD-78E16A26253F}" dt="2022-06-01T19:34:15.537" v="896" actId="1038"/>
          <ac:spMkLst>
            <pc:docMk/>
            <pc:sldMk cId="1493675132" sldId="267"/>
            <ac:spMk id="27" creationId="{416742F1-60F0-417B-AB9B-010564097C42}"/>
          </ac:spMkLst>
        </pc:spChg>
        <pc:spChg chg="mod">
          <ac:chgData name="Shirelle Liu" userId="9c120045ac198691" providerId="LiveId" clId="{0EEC9054-8E62-4D03-ABBD-78E16A26253F}" dt="2022-06-01T19:33:51.585" v="890" actId="1038"/>
          <ac:spMkLst>
            <pc:docMk/>
            <pc:sldMk cId="1493675132" sldId="267"/>
            <ac:spMk id="28" creationId="{CB7D2D0E-0826-42A4-A6C0-D8E28DC3FE54}"/>
          </ac:spMkLst>
        </pc:spChg>
        <pc:spChg chg="mod">
          <ac:chgData name="Shirelle Liu" userId="9c120045ac198691" providerId="LiveId" clId="{0EEC9054-8E62-4D03-ABBD-78E16A26253F}" dt="2022-06-01T19:33:36.883" v="887" actId="1038"/>
          <ac:spMkLst>
            <pc:docMk/>
            <pc:sldMk cId="1493675132" sldId="267"/>
            <ac:spMk id="29" creationId="{E3B3DBBC-D7B5-40F6-BFE7-27C5A1ACF952}"/>
          </ac:spMkLst>
        </pc:spChg>
        <pc:spChg chg="mod">
          <ac:chgData name="Shirelle Liu" userId="9c120045ac198691" providerId="LiveId" clId="{0EEC9054-8E62-4D03-ABBD-78E16A26253F}" dt="2022-06-01T19:33:28.520" v="884" actId="1038"/>
          <ac:spMkLst>
            <pc:docMk/>
            <pc:sldMk cId="1493675132" sldId="267"/>
            <ac:spMk id="30" creationId="{042E2FA0-DD62-4C89-B626-EBFB3BC65BEF}"/>
          </ac:spMkLst>
        </pc:spChg>
        <pc:spChg chg="mod">
          <ac:chgData name="Shirelle Liu" userId="9c120045ac198691" providerId="LiveId" clId="{0EEC9054-8E62-4D03-ABBD-78E16A26253F}" dt="2022-06-01T19:33:13.469" v="881" actId="1038"/>
          <ac:spMkLst>
            <pc:docMk/>
            <pc:sldMk cId="1493675132" sldId="267"/>
            <ac:spMk id="31" creationId="{B5D0432B-CAA1-4D7F-AA1F-4FE8A39E4558}"/>
          </ac:spMkLst>
        </pc:spChg>
        <pc:spChg chg="mod">
          <ac:chgData name="Shirelle Liu" userId="9c120045ac198691" providerId="LiveId" clId="{0EEC9054-8E62-4D03-ABBD-78E16A26253F}" dt="2022-06-01T19:32:56.502" v="878" actId="1038"/>
          <ac:spMkLst>
            <pc:docMk/>
            <pc:sldMk cId="1493675132" sldId="267"/>
            <ac:spMk id="32" creationId="{8533E214-80FC-42E2-A9CB-9E926C666B6E}"/>
          </ac:spMkLst>
        </pc:spChg>
        <pc:spChg chg="mod">
          <ac:chgData name="Shirelle Liu" userId="9c120045ac198691" providerId="LiveId" clId="{0EEC9054-8E62-4D03-ABBD-78E16A26253F}" dt="2022-06-01T19:32:44.177" v="876" actId="1038"/>
          <ac:spMkLst>
            <pc:docMk/>
            <pc:sldMk cId="1493675132" sldId="267"/>
            <ac:spMk id="33" creationId="{5464ED37-18FD-4819-8F01-A0C9471E2CA3}"/>
          </ac:spMkLst>
        </pc:spChg>
        <pc:spChg chg="mod">
          <ac:chgData name="Shirelle Liu" userId="9c120045ac198691" providerId="LiveId" clId="{0EEC9054-8E62-4D03-ABBD-78E16A26253F}" dt="2022-06-01T19:31:46.451" v="874" actId="1038"/>
          <ac:spMkLst>
            <pc:docMk/>
            <pc:sldMk cId="1493675132" sldId="267"/>
            <ac:spMk id="34" creationId="{207B7BFE-11AB-4ED6-A094-3908C71EC566}"/>
          </ac:spMkLst>
        </pc:spChg>
        <pc:spChg chg="mod">
          <ac:chgData name="Shirelle Liu" userId="9c120045ac198691" providerId="LiveId" clId="{0EEC9054-8E62-4D03-ABBD-78E16A26253F}" dt="2022-06-01T19:31:09.712" v="873" actId="1037"/>
          <ac:spMkLst>
            <pc:docMk/>
            <pc:sldMk cId="1493675132" sldId="267"/>
            <ac:spMk id="35" creationId="{E7B8A0B1-00D6-43AA-A9CD-F627A710451F}"/>
          </ac:spMkLst>
        </pc:spChg>
        <pc:spChg chg="del">
          <ac:chgData name="Shirelle Liu" userId="9c120045ac198691" providerId="LiveId" clId="{0EEC9054-8E62-4D03-ABBD-78E16A26253F}" dt="2022-06-01T19:24:38.226" v="814" actId="478"/>
          <ac:spMkLst>
            <pc:docMk/>
            <pc:sldMk cId="1493675132" sldId="267"/>
            <ac:spMk id="36" creationId="{B653E171-017B-4759-A9F8-85A06E6D9BF9}"/>
          </ac:spMkLst>
        </pc:spChg>
        <pc:spChg chg="mod">
          <ac:chgData name="Shirelle Liu" userId="9c120045ac198691" providerId="LiveId" clId="{0EEC9054-8E62-4D03-ABBD-78E16A26253F}" dt="2022-06-01T19:26:04.540" v="842" actId="1036"/>
          <ac:spMkLst>
            <pc:docMk/>
            <pc:sldMk cId="1493675132" sldId="267"/>
            <ac:spMk id="37" creationId="{7A1E2336-9383-4B0E-B4BA-B7C51E1B576F}"/>
          </ac:spMkLst>
        </pc:spChg>
        <pc:spChg chg="mod">
          <ac:chgData name="Shirelle Liu" userId="9c120045ac198691" providerId="LiveId" clId="{0EEC9054-8E62-4D03-ABBD-78E16A26253F}" dt="2022-06-01T19:26:41.544" v="848" actId="1035"/>
          <ac:spMkLst>
            <pc:docMk/>
            <pc:sldMk cId="1493675132" sldId="267"/>
            <ac:spMk id="38" creationId="{FF7B3306-3232-4BA0-923D-24FC15E4699B}"/>
          </ac:spMkLst>
        </pc:spChg>
        <pc:spChg chg="mod">
          <ac:chgData name="Shirelle Liu" userId="9c120045ac198691" providerId="LiveId" clId="{0EEC9054-8E62-4D03-ABBD-78E16A26253F}" dt="2022-06-01T19:27:45.303" v="858" actId="1036"/>
          <ac:spMkLst>
            <pc:docMk/>
            <pc:sldMk cId="1493675132" sldId="267"/>
            <ac:spMk id="39" creationId="{B82A6090-EEE0-454E-A155-DCE2DFE0CF9C}"/>
          </ac:spMkLst>
        </pc:spChg>
        <pc:spChg chg="mod">
          <ac:chgData name="Shirelle Liu" userId="9c120045ac198691" providerId="LiveId" clId="{0EEC9054-8E62-4D03-ABBD-78E16A26253F}" dt="2022-06-02T14:39:25.422" v="1131" actId="1076"/>
          <ac:spMkLst>
            <pc:docMk/>
            <pc:sldMk cId="1493675132" sldId="267"/>
            <ac:spMk id="40" creationId="{B42DD186-C2E5-4BF5-9CC4-E9B2BFF292AD}"/>
          </ac:spMkLst>
        </pc:spChg>
        <pc:spChg chg="del">
          <ac:chgData name="Shirelle Liu" userId="9c120045ac198691" providerId="LiveId" clId="{0EEC9054-8E62-4D03-ABBD-78E16A26253F}" dt="2022-06-02T14:31:30.551" v="967" actId="478"/>
          <ac:spMkLst>
            <pc:docMk/>
            <pc:sldMk cId="1493675132" sldId="267"/>
            <ac:spMk id="42" creationId="{5217ECE9-61D6-4BBE-B665-37B15265480B}"/>
          </ac:spMkLst>
        </pc:spChg>
        <pc:spChg chg="mod">
          <ac:chgData name="Shirelle Liu" userId="9c120045ac198691" providerId="LiveId" clId="{0EEC9054-8E62-4D03-ABBD-78E16A26253F}" dt="2022-06-02T14:31:40.944" v="981" actId="1036"/>
          <ac:spMkLst>
            <pc:docMk/>
            <pc:sldMk cId="1493675132" sldId="267"/>
            <ac:spMk id="43" creationId="{1B55C0E4-185A-4439-A7EF-65CB3E7867CF}"/>
          </ac:spMkLst>
        </pc:spChg>
        <pc:spChg chg="mod">
          <ac:chgData name="Shirelle Liu" userId="9c120045ac198691" providerId="LiveId" clId="{0EEC9054-8E62-4D03-ABBD-78E16A26253F}" dt="2022-06-02T14:31:50.812" v="995" actId="1035"/>
          <ac:spMkLst>
            <pc:docMk/>
            <pc:sldMk cId="1493675132" sldId="267"/>
            <ac:spMk id="44" creationId="{C661F41A-6E6B-4358-A625-17AC90ED3898}"/>
          </ac:spMkLst>
        </pc:spChg>
        <pc:spChg chg="mod">
          <ac:chgData name="Shirelle Liu" userId="9c120045ac198691" providerId="LiveId" clId="{0EEC9054-8E62-4D03-ABBD-78E16A26253F}" dt="2022-06-02T14:31:57.151" v="1009" actId="1036"/>
          <ac:spMkLst>
            <pc:docMk/>
            <pc:sldMk cId="1493675132" sldId="267"/>
            <ac:spMk id="45" creationId="{4CBBAF8B-4B90-4A8D-BCA4-09B267BD3528}"/>
          </ac:spMkLst>
        </pc:spChg>
        <pc:spChg chg="mod">
          <ac:chgData name="Shirelle Liu" userId="9c120045ac198691" providerId="LiveId" clId="{0EEC9054-8E62-4D03-ABBD-78E16A26253F}" dt="2022-06-02T14:32:13.168" v="1010" actId="1076"/>
          <ac:spMkLst>
            <pc:docMk/>
            <pc:sldMk cId="1493675132" sldId="267"/>
            <ac:spMk id="46" creationId="{F18B05B8-C1AA-4A81-92EA-D12C7970116B}"/>
          </ac:spMkLst>
        </pc:spChg>
        <pc:spChg chg="mod">
          <ac:chgData name="Shirelle Liu" userId="9c120045ac198691" providerId="LiveId" clId="{0EEC9054-8E62-4D03-ABBD-78E16A26253F}" dt="2022-06-02T14:32:34.827" v="1011" actId="1076"/>
          <ac:spMkLst>
            <pc:docMk/>
            <pc:sldMk cId="1493675132" sldId="267"/>
            <ac:spMk id="47" creationId="{673B5879-B0DD-4E60-9CF8-0C06AD7D68DD}"/>
          </ac:spMkLst>
        </pc:spChg>
        <pc:spChg chg="mod">
          <ac:chgData name="Shirelle Liu" userId="9c120045ac198691" providerId="LiveId" clId="{0EEC9054-8E62-4D03-ABBD-78E16A26253F}" dt="2022-06-02T14:33:00.852" v="1013" actId="1037"/>
          <ac:spMkLst>
            <pc:docMk/>
            <pc:sldMk cId="1493675132" sldId="267"/>
            <ac:spMk id="69" creationId="{BED66A0A-D6A3-4C87-B6A2-1AA9B951B418}"/>
          </ac:spMkLst>
        </pc:spChg>
        <pc:spChg chg="mod">
          <ac:chgData name="Shirelle Liu" userId="9c120045ac198691" providerId="LiveId" clId="{0EEC9054-8E62-4D03-ABBD-78E16A26253F}" dt="2022-06-02T14:39:05.812" v="1130" actId="1036"/>
          <ac:spMkLst>
            <pc:docMk/>
            <pc:sldMk cId="1493675132" sldId="267"/>
            <ac:spMk id="100" creationId="{D77EAC4B-7052-4D6F-9736-19959742CD11}"/>
          </ac:spMkLst>
        </pc:spChg>
        <pc:spChg chg="mod">
          <ac:chgData name="Shirelle Liu" userId="9c120045ac198691" providerId="LiveId" clId="{0EEC9054-8E62-4D03-ABBD-78E16A26253F}" dt="2022-06-02T14:38:26.149" v="1125" actId="1035"/>
          <ac:spMkLst>
            <pc:docMk/>
            <pc:sldMk cId="1493675132" sldId="267"/>
            <ac:spMk id="101" creationId="{27B70E8D-260B-4BE4-862F-39F1A849297D}"/>
          </ac:spMkLst>
        </pc:spChg>
        <pc:spChg chg="add mod">
          <ac:chgData name="Shirelle Liu" userId="9c120045ac198691" providerId="LiveId" clId="{0EEC9054-8E62-4D03-ABBD-78E16A26253F}" dt="2022-06-01T19:29:17.903" v="869" actId="1076"/>
          <ac:spMkLst>
            <pc:docMk/>
            <pc:sldMk cId="1493675132" sldId="267"/>
            <ac:spMk id="102" creationId="{380ED0DD-BA5D-473C-B01B-6BB54F62AF8E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05" creationId="{A53BA0FD-6302-4F18-9378-AB2CA1119C2E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06" creationId="{982A68D7-8C6C-44F5-8B7C-1A7A4429C06E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07" creationId="{7D3CEF04-90EE-4431-9ECE-A768E2BF92EB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08" creationId="{AC67D4FC-46D9-40EB-94EF-52F0DF3B0D83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09" creationId="{D9F5D3D5-B9F1-4928-8E54-143289523E4C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0" creationId="{1B4AB0E1-6C4E-4F41-B123-92044CC0B7A8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1" creationId="{1A209E4F-A53E-4FC9-9CDA-5F5EDAA921E9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2" creationId="{60D99A5E-73B7-4C4B-A3B5-BCAFC75847E1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3" creationId="{E1F6AF8D-9245-4D4C-A5B4-D363BCF1144B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4" creationId="{EA6963A3-70DB-4302-A2DC-785D6CE6BCE6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5" creationId="{E25E2865-AF34-4F96-B636-B93FA531A15A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6" creationId="{D8E491EE-60EA-4951-BD9D-30ACA02DBD37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7" creationId="{DEBFB52A-8E2A-47EE-B97F-9ABECDC47F4D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8" creationId="{8EF88D10-170D-4650-B272-70DCC962FE51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19" creationId="{19482130-7CA9-4058-A089-FFDBE894895A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20" creationId="{E64757DF-D714-455F-8C99-C2E844E782C9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21" creationId="{17D33D1B-3ABC-481E-B2B8-999E887C02D1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22" creationId="{E0D404EB-FF83-4E29-B763-7FD1949397C2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23" creationId="{D720C1C9-0736-4A78-9C33-186E387AA139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24" creationId="{26C7E29C-C42E-4AEB-A5D9-DD96DB0AEF27}"/>
          </ac:spMkLst>
        </pc:spChg>
        <pc:spChg chg="mod">
          <ac:chgData name="Shirelle Liu" userId="9c120045ac198691" providerId="LiveId" clId="{0EEC9054-8E62-4D03-ABBD-78E16A26253F}" dt="2022-06-02T14:36:34.818" v="1045"/>
          <ac:spMkLst>
            <pc:docMk/>
            <pc:sldMk cId="1493675132" sldId="267"/>
            <ac:spMk id="125" creationId="{4ADBCCC4-0564-4CB1-8F0E-C66549BDC92D}"/>
          </ac:spMkLst>
        </pc:spChg>
        <pc:spChg chg="mod">
          <ac:chgData name="Shirelle Liu" userId="9c120045ac198691" providerId="LiveId" clId="{0EEC9054-8E62-4D03-ABBD-78E16A26253F}" dt="2022-06-02T14:37:23.139" v="1116" actId="1036"/>
          <ac:spMkLst>
            <pc:docMk/>
            <pc:sldMk cId="1493675132" sldId="267"/>
            <ac:spMk id="127" creationId="{5FD46743-D821-4476-8D0B-A271958E694A}"/>
          </ac:spMkLst>
        </pc:spChg>
        <pc:spChg chg="mod">
          <ac:chgData name="Shirelle Liu" userId="9c120045ac198691" providerId="LiveId" clId="{0EEC9054-8E62-4D03-ABBD-78E16A26253F}" dt="2022-06-02T14:37:18.264" v="1108" actId="1036"/>
          <ac:spMkLst>
            <pc:docMk/>
            <pc:sldMk cId="1493675132" sldId="267"/>
            <ac:spMk id="128" creationId="{014BE8A7-B77A-4EFE-8262-9DB9BBDD8033}"/>
          </ac:spMkLst>
        </pc:spChg>
        <pc:spChg chg="mod">
          <ac:chgData name="Shirelle Liu" userId="9c120045ac198691" providerId="LiveId" clId="{0EEC9054-8E62-4D03-ABBD-78E16A26253F}" dt="2022-06-02T14:36:52.970" v="1098"/>
          <ac:spMkLst>
            <pc:docMk/>
            <pc:sldMk cId="1493675132" sldId="267"/>
            <ac:spMk id="129" creationId="{446455CB-A038-4A7C-988E-D2070756B143}"/>
          </ac:spMkLst>
        </pc:spChg>
        <pc:spChg chg="mod">
          <ac:chgData name="Shirelle Liu" userId="9c120045ac198691" providerId="LiveId" clId="{0EEC9054-8E62-4D03-ABBD-78E16A26253F}" dt="2022-06-02T14:36:52.970" v="1098"/>
          <ac:spMkLst>
            <pc:docMk/>
            <pc:sldMk cId="1493675132" sldId="267"/>
            <ac:spMk id="130" creationId="{A7781989-FDE2-49B2-896A-B9B8AB0E6441}"/>
          </ac:spMkLst>
        </pc:spChg>
        <pc:spChg chg="mod">
          <ac:chgData name="Shirelle Liu" userId="9c120045ac198691" providerId="LiveId" clId="{0EEC9054-8E62-4D03-ABBD-78E16A26253F}" dt="2022-06-02T14:37:12.644" v="1104" actId="20577"/>
          <ac:spMkLst>
            <pc:docMk/>
            <pc:sldMk cId="1493675132" sldId="267"/>
            <ac:spMk id="131" creationId="{2048F19E-6778-48D7-AF06-95FA422469A2}"/>
          </ac:spMkLst>
        </pc:spChg>
        <pc:grpChg chg="mod">
          <ac:chgData name="Shirelle Liu" userId="9c120045ac198691" providerId="LiveId" clId="{0EEC9054-8E62-4D03-ABBD-78E16A26253F}" dt="2022-06-01T19:44:26.531" v="961" actId="1035"/>
          <ac:grpSpMkLst>
            <pc:docMk/>
            <pc:sldMk cId="1493675132" sldId="267"/>
            <ac:grpSpMk id="11" creationId="{6FC6F9EA-33EF-45D0-A82D-3550C7EA9C6B}"/>
          </ac:grpSpMkLst>
        </pc:grpChg>
        <pc:grpChg chg="mod">
          <ac:chgData name="Shirelle Liu" userId="9c120045ac198691" providerId="LiveId" clId="{0EEC9054-8E62-4D03-ABBD-78E16A26253F}" dt="2022-06-02T14:38:55.821" v="1129" actId="1035"/>
          <ac:grpSpMkLst>
            <pc:docMk/>
            <pc:sldMk cId="1493675132" sldId="267"/>
            <ac:grpSpMk id="41" creationId="{E3D0D9C5-6FB5-47B4-9C48-17339A708872}"/>
          </ac:grpSpMkLst>
        </pc:grpChg>
        <pc:grpChg chg="mod">
          <ac:chgData name="Shirelle Liu" userId="9c120045ac198691" providerId="LiveId" clId="{0EEC9054-8E62-4D03-ABBD-78E16A26253F}" dt="2022-06-02T14:38:55.821" v="1129" actId="1035"/>
          <ac:grpSpMkLst>
            <pc:docMk/>
            <pc:sldMk cId="1493675132" sldId="267"/>
            <ac:grpSpMk id="48" creationId="{AD71EC1F-F97C-4A3D-BF5B-006BF07AE50C}"/>
          </ac:grpSpMkLst>
        </pc:grpChg>
        <pc:grpChg chg="del">
          <ac:chgData name="Shirelle Liu" userId="9c120045ac198691" providerId="LiveId" clId="{0EEC9054-8E62-4D03-ABBD-78E16A26253F}" dt="2022-06-02T14:36:56.271" v="1099" actId="478"/>
          <ac:grpSpMkLst>
            <pc:docMk/>
            <pc:sldMk cId="1493675132" sldId="267"/>
            <ac:grpSpMk id="70" creationId="{B1F8BD26-91D3-4385-B156-B7E0FDB160AE}"/>
          </ac:grpSpMkLst>
        </pc:grpChg>
        <pc:grpChg chg="del">
          <ac:chgData name="Shirelle Liu" userId="9c120045ac198691" providerId="LiveId" clId="{0EEC9054-8E62-4D03-ABBD-78E16A26253F}" dt="2022-06-02T14:36:29.323" v="1044" actId="478"/>
          <ac:grpSpMkLst>
            <pc:docMk/>
            <pc:sldMk cId="1493675132" sldId="267"/>
            <ac:grpSpMk id="77" creationId="{A8586CEE-FD31-4320-9F42-DBC19621E631}"/>
          </ac:grpSpMkLst>
        </pc:grpChg>
        <pc:grpChg chg="add mod">
          <ac:chgData name="Shirelle Liu" userId="9c120045ac198691" providerId="LiveId" clId="{0EEC9054-8E62-4D03-ABBD-78E16A26253F}" dt="2022-06-02T14:37:39.772" v="1120" actId="1037"/>
          <ac:grpSpMkLst>
            <pc:docMk/>
            <pc:sldMk cId="1493675132" sldId="267"/>
            <ac:grpSpMk id="104" creationId="{F6B01311-4552-4244-82DF-D39FF7B9172B}"/>
          </ac:grpSpMkLst>
        </pc:grpChg>
        <pc:grpChg chg="add mod">
          <ac:chgData name="Shirelle Liu" userId="9c120045ac198691" providerId="LiveId" clId="{0EEC9054-8E62-4D03-ABBD-78E16A26253F}" dt="2022-06-02T14:37:07.354" v="1100" actId="1076"/>
          <ac:grpSpMkLst>
            <pc:docMk/>
            <pc:sldMk cId="1493675132" sldId="267"/>
            <ac:grpSpMk id="126" creationId="{E9FD0165-C38C-42DA-B92E-75714C7FFA3A}"/>
          </ac:grpSpMkLst>
        </pc:grpChg>
        <pc:picChg chg="add mod ord modCrop">
          <ac:chgData name="Shirelle Liu" userId="9c120045ac198691" providerId="LiveId" clId="{0EEC9054-8E62-4D03-ABBD-78E16A26253F}" dt="2022-06-01T19:44:08.499" v="956" actId="732"/>
          <ac:picMkLst>
            <pc:docMk/>
            <pc:sldMk cId="1493675132" sldId="267"/>
            <ac:picMk id="2" creationId="{2A80041B-F641-436B-9F0A-9B853B5251D1}"/>
          </ac:picMkLst>
        </pc:picChg>
        <pc:picChg chg="add mod">
          <ac:chgData name="Shirelle Liu" userId="9c120045ac198691" providerId="LiveId" clId="{0EEC9054-8E62-4D03-ABBD-78E16A26253F}" dt="2022-06-02T14:36:25.572" v="1043" actId="14100"/>
          <ac:picMkLst>
            <pc:docMk/>
            <pc:sldMk cId="1493675132" sldId="267"/>
            <ac:picMk id="3" creationId="{15E11FDA-129E-411E-834F-7D2F1390D371}"/>
          </ac:picMkLst>
        </pc:picChg>
        <pc:picChg chg="del">
          <ac:chgData name="Shirelle Liu" userId="9c120045ac198691" providerId="LiveId" clId="{0EEC9054-8E62-4D03-ABBD-78E16A26253F}" dt="2022-06-01T19:23:18.256" v="808" actId="478"/>
          <ac:picMkLst>
            <pc:docMk/>
            <pc:sldMk cId="1493675132" sldId="267"/>
            <ac:picMk id="4" creationId="{B7581E32-D1C1-4B53-A0C4-8E1373EAF351}"/>
          </ac:picMkLst>
        </pc:picChg>
        <pc:picChg chg="del">
          <ac:chgData name="Shirelle Liu" userId="9c120045ac198691" providerId="LiveId" clId="{0EEC9054-8E62-4D03-ABBD-78E16A26253F}" dt="2022-06-01T19:44:58.489" v="964" actId="478"/>
          <ac:picMkLst>
            <pc:docMk/>
            <pc:sldMk cId="1493675132" sldId="267"/>
            <ac:picMk id="6" creationId="{B89E8DAB-352D-4936-8BC5-0996AA8D7E77}"/>
          </ac:picMkLst>
        </pc:picChg>
        <pc:picChg chg="del">
          <ac:chgData name="Shirelle Liu" userId="9c120045ac198691" providerId="LiveId" clId="{0EEC9054-8E62-4D03-ABBD-78E16A26253F}" dt="2022-06-02T14:32:44.859" v="1012" actId="478"/>
          <ac:picMkLst>
            <pc:docMk/>
            <pc:sldMk cId="1493675132" sldId="267"/>
            <ac:picMk id="8" creationId="{A868B542-A543-4173-BA62-C187A04BCF52}"/>
          </ac:picMkLst>
        </pc:picChg>
        <pc:picChg chg="add mod">
          <ac:chgData name="Shirelle Liu" userId="9c120045ac198691" providerId="LiveId" clId="{0EEC9054-8E62-4D03-ABBD-78E16A26253F}" dt="2022-06-02T14:38:55.821" v="1129" actId="1035"/>
          <ac:picMkLst>
            <pc:docMk/>
            <pc:sldMk cId="1493675132" sldId="267"/>
            <ac:picMk id="103" creationId="{69C76608-74B5-44B1-B922-1BE67151B3B0}"/>
          </ac:picMkLst>
        </pc:picChg>
      </pc:sldChg>
      <pc:sldChg chg="add del">
        <pc:chgData name="Shirelle Liu" userId="9c120045ac198691" providerId="LiveId" clId="{0EEC9054-8E62-4D03-ABBD-78E16A26253F}" dt="2022-06-01T19:19:46.473" v="794" actId="47"/>
        <pc:sldMkLst>
          <pc:docMk/>
          <pc:sldMk cId="2791299815" sldId="26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294BE7-5340-784D-A7AE-0DF65C63E755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8D5D45-0FE2-B944-88E8-0142FFB25B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477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1: Peak distributions for ATAC- (A) and H3K9me3 </a:t>
            </a:r>
            <a:r>
              <a:rPr lang="en-US" dirty="0" err="1"/>
              <a:t>ChIP</a:t>
            </a:r>
            <a:r>
              <a:rPr lang="en-US" dirty="0"/>
              <a:t>-seq (B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8D5D45-0FE2-B944-88E8-0142FFB25B4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0912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: Manhattan plots for ATAC-seq peak calling, ID/IS (A), </a:t>
            </a:r>
            <a:r>
              <a:rPr lang="en-US" dirty="0" err="1"/>
              <a:t>IDch</a:t>
            </a:r>
            <a:r>
              <a:rPr lang="en-US" dirty="0"/>
              <a:t>/IS (B), and </a:t>
            </a:r>
            <a:r>
              <a:rPr lang="en-US" dirty="0" err="1"/>
              <a:t>ISch</a:t>
            </a:r>
            <a:r>
              <a:rPr lang="en-US" dirty="0"/>
              <a:t>/IS (C), showing similar patterns between ID and </a:t>
            </a:r>
            <a:r>
              <a:rPr lang="en-US" dirty="0" err="1"/>
              <a:t>ISch</a:t>
            </a:r>
            <a:r>
              <a:rPr lang="en-US" dirty="0"/>
              <a:t> group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8D5D45-0FE2-B944-88E8-0142FFB25B4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838666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3: Manhattan plots for H3K9me3 </a:t>
            </a:r>
            <a:r>
              <a:rPr lang="en-US" dirty="0" err="1"/>
              <a:t>ChIP</a:t>
            </a:r>
            <a:r>
              <a:rPr lang="en-US" dirty="0"/>
              <a:t>-seq peak calling, ID/IS (A), </a:t>
            </a:r>
            <a:r>
              <a:rPr lang="en-US" dirty="0" err="1"/>
              <a:t>IDch</a:t>
            </a:r>
            <a:r>
              <a:rPr lang="en-US" dirty="0"/>
              <a:t>/IS (B), and </a:t>
            </a:r>
            <a:r>
              <a:rPr lang="en-US" dirty="0" err="1"/>
              <a:t>ISch</a:t>
            </a:r>
            <a:r>
              <a:rPr lang="en-US" dirty="0"/>
              <a:t>/IS (C)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F8D5D45-0FE2-B944-88E8-0142FFB25B4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4031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4273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02250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94812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3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320"/>
            </a:lvl1pPr>
            <a:lvl2pPr marL="251460" indent="0" algn="ctr">
              <a:buNone/>
              <a:defRPr sz="1100"/>
            </a:lvl2pPr>
            <a:lvl3pPr marL="502920" indent="0" algn="ctr">
              <a:buNone/>
              <a:defRPr sz="990"/>
            </a:lvl3pPr>
            <a:lvl4pPr marL="754380" indent="0" algn="ctr">
              <a:buNone/>
              <a:defRPr sz="880"/>
            </a:lvl4pPr>
            <a:lvl5pPr marL="1005840" indent="0" algn="ctr">
              <a:buNone/>
              <a:defRPr sz="880"/>
            </a:lvl5pPr>
            <a:lvl6pPr marL="1257300" indent="0" algn="ctr">
              <a:buNone/>
              <a:defRPr sz="880"/>
            </a:lvl6pPr>
            <a:lvl7pPr marL="1508760" indent="0" algn="ctr">
              <a:buNone/>
              <a:defRPr sz="880"/>
            </a:lvl7pPr>
            <a:lvl8pPr marL="1760220" indent="0" algn="ctr">
              <a:buNone/>
              <a:defRPr sz="880"/>
            </a:lvl8pPr>
            <a:lvl9pPr marL="2011680" indent="0" algn="ctr">
              <a:buNone/>
              <a:defRPr sz="8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571705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03294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0"/>
            <a:ext cx="7886700" cy="2852737"/>
          </a:xfrm>
        </p:spPr>
        <p:txBody>
          <a:bodyPr anchor="b"/>
          <a:lstStyle>
            <a:lvl1pPr>
              <a:defRPr sz="3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5"/>
            <a:ext cx="7886700" cy="1500187"/>
          </a:xfrm>
        </p:spPr>
        <p:txBody>
          <a:bodyPr/>
          <a:lstStyle>
            <a:lvl1pPr marL="0" indent="0">
              <a:buNone/>
              <a:defRPr sz="1320">
                <a:solidFill>
                  <a:schemeClr val="tx1"/>
                </a:solidFill>
              </a:defRPr>
            </a:lvl1pPr>
            <a:lvl2pPr marL="251460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2pPr>
            <a:lvl3pPr marL="502920" indent="0">
              <a:buNone/>
              <a:defRPr sz="990">
                <a:solidFill>
                  <a:schemeClr val="tx1">
                    <a:tint val="75000"/>
                  </a:schemeClr>
                </a:solidFill>
              </a:defRPr>
            </a:lvl3pPr>
            <a:lvl4pPr marL="75438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4pPr>
            <a:lvl5pPr marL="100584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5pPr>
            <a:lvl6pPr marL="125730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6pPr>
            <a:lvl7pPr marL="150876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7pPr>
            <a:lvl8pPr marL="176022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8pPr>
            <a:lvl9pPr marL="2011680" indent="0">
              <a:buNone/>
              <a:defRPr sz="8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06828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02561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320" b="1"/>
            </a:lvl1pPr>
            <a:lvl2pPr marL="251460" indent="0">
              <a:buNone/>
              <a:defRPr sz="1100" b="1"/>
            </a:lvl2pPr>
            <a:lvl3pPr marL="502920" indent="0">
              <a:buNone/>
              <a:defRPr sz="990" b="1"/>
            </a:lvl3pPr>
            <a:lvl4pPr marL="754380" indent="0">
              <a:buNone/>
              <a:defRPr sz="880" b="1"/>
            </a:lvl4pPr>
            <a:lvl5pPr marL="1005840" indent="0">
              <a:buNone/>
              <a:defRPr sz="880" b="1"/>
            </a:lvl5pPr>
            <a:lvl6pPr marL="1257300" indent="0">
              <a:buNone/>
              <a:defRPr sz="880" b="1"/>
            </a:lvl6pPr>
            <a:lvl7pPr marL="1508760" indent="0">
              <a:buNone/>
              <a:defRPr sz="880" b="1"/>
            </a:lvl7pPr>
            <a:lvl8pPr marL="1760220" indent="0">
              <a:buNone/>
              <a:defRPr sz="880" b="1"/>
            </a:lvl8pPr>
            <a:lvl9pPr marL="2011680" indent="0">
              <a:buNone/>
              <a:defRPr sz="8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1320" b="1"/>
            </a:lvl1pPr>
            <a:lvl2pPr marL="251460" indent="0">
              <a:buNone/>
              <a:defRPr sz="1100" b="1"/>
            </a:lvl2pPr>
            <a:lvl3pPr marL="502920" indent="0">
              <a:buNone/>
              <a:defRPr sz="990" b="1"/>
            </a:lvl3pPr>
            <a:lvl4pPr marL="754380" indent="0">
              <a:buNone/>
              <a:defRPr sz="880" b="1"/>
            </a:lvl4pPr>
            <a:lvl5pPr marL="1005840" indent="0">
              <a:buNone/>
              <a:defRPr sz="880" b="1"/>
            </a:lvl5pPr>
            <a:lvl6pPr marL="1257300" indent="0">
              <a:buNone/>
              <a:defRPr sz="880" b="1"/>
            </a:lvl6pPr>
            <a:lvl7pPr marL="1508760" indent="0">
              <a:buNone/>
              <a:defRPr sz="880" b="1"/>
            </a:lvl7pPr>
            <a:lvl8pPr marL="1760220" indent="0">
              <a:buNone/>
              <a:defRPr sz="880" b="1"/>
            </a:lvl8pPr>
            <a:lvl9pPr marL="2011680" indent="0">
              <a:buNone/>
              <a:defRPr sz="8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705919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21932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522086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0" cy="4873625"/>
          </a:xfrm>
        </p:spPr>
        <p:txBody>
          <a:bodyPr/>
          <a:lstStyle>
            <a:lvl1pPr>
              <a:defRPr sz="1760"/>
            </a:lvl1pPr>
            <a:lvl2pPr>
              <a:defRPr sz="1540"/>
            </a:lvl2pPr>
            <a:lvl3pPr>
              <a:defRPr sz="1320"/>
            </a:lvl3pPr>
            <a:lvl4pPr>
              <a:defRPr sz="1100"/>
            </a:lvl4pPr>
            <a:lvl5pPr>
              <a:defRPr sz="1100"/>
            </a:lvl5pPr>
            <a:lvl6pPr>
              <a:defRPr sz="1100"/>
            </a:lvl6pPr>
            <a:lvl7pPr>
              <a:defRPr sz="1100"/>
            </a:lvl7pPr>
            <a:lvl8pPr>
              <a:defRPr sz="1100"/>
            </a:lvl8pPr>
            <a:lvl9pPr>
              <a:defRPr sz="1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880"/>
            </a:lvl1pPr>
            <a:lvl2pPr marL="251460" indent="0">
              <a:buNone/>
              <a:defRPr sz="770"/>
            </a:lvl2pPr>
            <a:lvl3pPr marL="502920" indent="0">
              <a:buNone/>
              <a:defRPr sz="660"/>
            </a:lvl3pPr>
            <a:lvl4pPr marL="754380" indent="0">
              <a:buNone/>
              <a:defRPr sz="550"/>
            </a:lvl4pPr>
            <a:lvl5pPr marL="1005840" indent="0">
              <a:buNone/>
              <a:defRPr sz="550"/>
            </a:lvl5pPr>
            <a:lvl6pPr marL="1257300" indent="0">
              <a:buNone/>
              <a:defRPr sz="550"/>
            </a:lvl6pPr>
            <a:lvl7pPr marL="1508760" indent="0">
              <a:buNone/>
              <a:defRPr sz="550"/>
            </a:lvl7pPr>
            <a:lvl8pPr marL="1760220" indent="0">
              <a:buNone/>
              <a:defRPr sz="550"/>
            </a:lvl8pPr>
            <a:lvl9pPr marL="2011680" indent="0">
              <a:buNone/>
              <a:defRPr sz="5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781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3346143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0" cy="4873625"/>
          </a:xfrm>
        </p:spPr>
        <p:txBody>
          <a:bodyPr anchor="t"/>
          <a:lstStyle>
            <a:lvl1pPr marL="0" indent="0">
              <a:buNone/>
              <a:defRPr sz="1760"/>
            </a:lvl1pPr>
            <a:lvl2pPr marL="251460" indent="0">
              <a:buNone/>
              <a:defRPr sz="1540"/>
            </a:lvl2pPr>
            <a:lvl3pPr marL="502920" indent="0">
              <a:buNone/>
              <a:defRPr sz="1320"/>
            </a:lvl3pPr>
            <a:lvl4pPr marL="754380" indent="0">
              <a:buNone/>
              <a:defRPr sz="1100"/>
            </a:lvl4pPr>
            <a:lvl5pPr marL="1005840" indent="0">
              <a:buNone/>
              <a:defRPr sz="1100"/>
            </a:lvl5pPr>
            <a:lvl6pPr marL="1257300" indent="0">
              <a:buNone/>
              <a:defRPr sz="1100"/>
            </a:lvl6pPr>
            <a:lvl7pPr marL="1508760" indent="0">
              <a:buNone/>
              <a:defRPr sz="1100"/>
            </a:lvl7pPr>
            <a:lvl8pPr marL="1760220" indent="0">
              <a:buNone/>
              <a:defRPr sz="1100"/>
            </a:lvl8pPr>
            <a:lvl9pPr marL="2011680" indent="0">
              <a:buNone/>
              <a:defRPr sz="1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880"/>
            </a:lvl1pPr>
            <a:lvl2pPr marL="251460" indent="0">
              <a:buNone/>
              <a:defRPr sz="770"/>
            </a:lvl2pPr>
            <a:lvl3pPr marL="502920" indent="0">
              <a:buNone/>
              <a:defRPr sz="660"/>
            </a:lvl3pPr>
            <a:lvl4pPr marL="754380" indent="0">
              <a:buNone/>
              <a:defRPr sz="550"/>
            </a:lvl4pPr>
            <a:lvl5pPr marL="1005840" indent="0">
              <a:buNone/>
              <a:defRPr sz="550"/>
            </a:lvl5pPr>
            <a:lvl6pPr marL="1257300" indent="0">
              <a:buNone/>
              <a:defRPr sz="550"/>
            </a:lvl6pPr>
            <a:lvl7pPr marL="1508760" indent="0">
              <a:buNone/>
              <a:defRPr sz="550"/>
            </a:lvl7pPr>
            <a:lvl8pPr marL="1760220" indent="0">
              <a:buNone/>
              <a:defRPr sz="550"/>
            </a:lvl8pPr>
            <a:lvl9pPr marL="2011680" indent="0">
              <a:buNone/>
              <a:defRPr sz="5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13075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17815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2399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577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5708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50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66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5757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35403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89094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2EA211-4336-3F44-8885-C283954C9C69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FBBECB-B4D3-784E-9CA6-51714336A63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390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E3C72C-0319-194E-AE75-A2FC97754560}" type="datetimeFigureOut">
              <a:rPr lang="en-US" smtClean="0"/>
              <a:t>6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CA665A-DA3D-EC47-8CFA-70344D854A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307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02920" rtl="0" eaLnBrk="1" latinLnBrk="0" hangingPunct="1">
        <a:lnSpc>
          <a:spcPct val="90000"/>
        </a:lnSpc>
        <a:spcBef>
          <a:spcPct val="0"/>
        </a:spcBef>
        <a:buNone/>
        <a:defRPr sz="24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5730" indent="-125730" algn="l" defTabSz="50292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540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1320" kern="1200">
          <a:solidFill>
            <a:schemeClr val="tx1"/>
          </a:solidFill>
          <a:latin typeface="+mn-lt"/>
          <a:ea typeface="+mn-ea"/>
          <a:cs typeface="+mn-cs"/>
        </a:defRPr>
      </a:lvl2pPr>
      <a:lvl3pPr marL="62865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1100" kern="1200">
          <a:solidFill>
            <a:schemeClr val="tx1"/>
          </a:solidFill>
          <a:latin typeface="+mn-lt"/>
          <a:ea typeface="+mn-ea"/>
          <a:cs typeface="+mn-cs"/>
        </a:defRPr>
      </a:lvl3pPr>
      <a:lvl4pPr marL="88011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4pPr>
      <a:lvl5pPr marL="113157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5pPr>
      <a:lvl6pPr marL="138303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6pPr>
      <a:lvl7pPr marL="163449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7pPr>
      <a:lvl8pPr marL="188595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8pPr>
      <a:lvl9pPr marL="2137410" indent="-125730" algn="l" defTabSz="502920" rtl="0" eaLnBrk="1" latinLnBrk="0" hangingPunct="1">
        <a:lnSpc>
          <a:spcPct val="90000"/>
        </a:lnSpc>
        <a:spcBef>
          <a:spcPts val="275"/>
        </a:spcBef>
        <a:buFont typeface="Arial" panose="020B0604020202020204" pitchFamily="34" charset="0"/>
        <a:buChar char="•"/>
        <a:defRPr sz="9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1pPr>
      <a:lvl2pPr marL="25146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2pPr>
      <a:lvl3pPr marL="50292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3pPr>
      <a:lvl4pPr marL="75438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4pPr>
      <a:lvl5pPr marL="100584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5pPr>
      <a:lvl6pPr marL="125730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6pPr>
      <a:lvl7pPr marL="150876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7pPr>
      <a:lvl8pPr marL="176022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8pPr>
      <a:lvl9pPr marL="2011680" algn="l" defTabSz="502920" rtl="0" eaLnBrk="1" latinLnBrk="0" hangingPunct="1">
        <a:defRPr sz="9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8.pn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027C37F-E6AC-0F43-8A92-DAEDD189C7D9}"/>
              </a:ext>
            </a:extLst>
          </p:cNvPr>
          <p:cNvSpPr txBox="1"/>
          <p:nvPr/>
        </p:nvSpPr>
        <p:spPr>
          <a:xfrm>
            <a:off x="2116476" y="11475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23FCBDB-8B0B-7647-8A52-B80D0B35BA9B}"/>
              </a:ext>
            </a:extLst>
          </p:cNvPr>
          <p:cNvSpPr txBox="1"/>
          <p:nvPr/>
        </p:nvSpPr>
        <p:spPr>
          <a:xfrm>
            <a:off x="2116476" y="383378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2CC7B41-EC3B-184C-944C-97C86E4E3A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72000" y="4018451"/>
            <a:ext cx="3600000" cy="222641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9CFF177-14C3-5C41-A1FF-90326C75E48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72000" y="1332222"/>
            <a:ext cx="3600000" cy="22789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25093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Background pattern&#10;&#10;Description automatically generated">
            <a:extLst>
              <a:ext uri="{FF2B5EF4-FFF2-40B4-BE49-F238E27FC236}">
                <a16:creationId xmlns:a16="http://schemas.microsoft.com/office/drawing/2014/main" id="{B7581E32-D1C1-4B53-A0C4-8E1373EAF35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82" t="5496" b="7956"/>
          <a:stretch/>
        </p:blipFill>
        <p:spPr>
          <a:xfrm>
            <a:off x="1820090" y="104502"/>
            <a:ext cx="6066609" cy="1924595"/>
          </a:xfrm>
          <a:prstGeom prst="rect">
            <a:avLst/>
          </a:prstGeom>
        </p:spPr>
      </p:pic>
      <p:pic>
        <p:nvPicPr>
          <p:cNvPr id="6" name="Picture 5" descr="Background pattern&#10;&#10;Description automatically generated">
            <a:extLst>
              <a:ext uri="{FF2B5EF4-FFF2-40B4-BE49-F238E27FC236}">
                <a16:creationId xmlns:a16="http://schemas.microsoft.com/office/drawing/2014/main" id="{B89E8DAB-352D-4936-8BC5-0996AA8D7E7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503" t="5318" b="7583"/>
          <a:stretch/>
        </p:blipFill>
        <p:spPr>
          <a:xfrm>
            <a:off x="1820091" y="2323807"/>
            <a:ext cx="6106892" cy="1948459"/>
          </a:xfrm>
          <a:prstGeom prst="round2SameRect">
            <a:avLst/>
          </a:prstGeom>
        </p:spPr>
      </p:pic>
      <p:pic>
        <p:nvPicPr>
          <p:cNvPr id="8" name="Picture 7" descr="Background pattern&#10;&#10;Description automatically generated">
            <a:extLst>
              <a:ext uri="{FF2B5EF4-FFF2-40B4-BE49-F238E27FC236}">
                <a16:creationId xmlns:a16="http://schemas.microsoft.com/office/drawing/2014/main" id="{A868B542-A543-4173-BA62-C187A04BCF5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503" t="5226" b="7674"/>
          <a:stretch/>
        </p:blipFill>
        <p:spPr>
          <a:xfrm>
            <a:off x="1820562" y="4598613"/>
            <a:ext cx="6106892" cy="1948459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6FC6F9EA-33EF-45D0-A82D-3550C7EA9C6B}"/>
              </a:ext>
            </a:extLst>
          </p:cNvPr>
          <p:cNvGrpSpPr/>
          <p:nvPr/>
        </p:nvGrpSpPr>
        <p:grpSpPr>
          <a:xfrm>
            <a:off x="2275966" y="2002973"/>
            <a:ext cx="5293233" cy="215444"/>
            <a:chOff x="2275966" y="2002973"/>
            <a:chExt cx="5293233" cy="215444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19BD6A9-01A6-4C69-A401-4AF223AAFA4A}"/>
                </a:ext>
              </a:extLst>
            </p:cNvPr>
            <p:cNvSpPr txBox="1"/>
            <p:nvPr/>
          </p:nvSpPr>
          <p:spPr>
            <a:xfrm>
              <a:off x="2275966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8860C2D-A2DF-48CF-BB78-61756720671F}"/>
                </a:ext>
              </a:extLst>
            </p:cNvPr>
            <p:cNvSpPr txBox="1"/>
            <p:nvPr/>
          </p:nvSpPr>
          <p:spPr>
            <a:xfrm>
              <a:off x="2826902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5CC37A0-24BA-4499-B912-A4CDDD83E0BA}"/>
                </a:ext>
              </a:extLst>
            </p:cNvPr>
            <p:cNvSpPr txBox="1"/>
            <p:nvPr/>
          </p:nvSpPr>
          <p:spPr>
            <a:xfrm>
              <a:off x="326536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8BE2E8A-EDA4-4B5F-9918-E0BBAB4E58B3}"/>
                </a:ext>
              </a:extLst>
            </p:cNvPr>
            <p:cNvSpPr txBox="1"/>
            <p:nvPr/>
          </p:nvSpPr>
          <p:spPr>
            <a:xfrm>
              <a:off x="3634885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DF7C57E-59FD-4EB9-8112-568917DA60F8}"/>
                </a:ext>
              </a:extLst>
            </p:cNvPr>
            <p:cNvSpPr txBox="1"/>
            <p:nvPr/>
          </p:nvSpPr>
          <p:spPr>
            <a:xfrm>
              <a:off x="3994285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BAC4277-0DA2-45B9-A048-8C31D58ECADC}"/>
                </a:ext>
              </a:extLst>
            </p:cNvPr>
            <p:cNvSpPr txBox="1"/>
            <p:nvPr/>
          </p:nvSpPr>
          <p:spPr>
            <a:xfrm>
              <a:off x="4313771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758508A-EDAA-40B9-B99C-C6B59D8D32AA}"/>
                </a:ext>
              </a:extLst>
            </p:cNvPr>
            <p:cNvSpPr txBox="1"/>
            <p:nvPr/>
          </p:nvSpPr>
          <p:spPr>
            <a:xfrm>
              <a:off x="4606953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31DEA9A-2353-45F1-BCC9-ACC7638D4F11}"/>
                </a:ext>
              </a:extLst>
            </p:cNvPr>
            <p:cNvSpPr txBox="1"/>
            <p:nvPr/>
          </p:nvSpPr>
          <p:spPr>
            <a:xfrm>
              <a:off x="4874008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054BA0A-2D11-4A71-917F-BBEB44CDF290}"/>
                </a:ext>
              </a:extLst>
            </p:cNvPr>
            <p:cNvSpPr txBox="1"/>
            <p:nvPr/>
          </p:nvSpPr>
          <p:spPr>
            <a:xfrm>
              <a:off x="512376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EB08545-2BC9-4109-A742-22D5F4040E52}"/>
                </a:ext>
              </a:extLst>
            </p:cNvPr>
            <p:cNvSpPr txBox="1"/>
            <p:nvPr/>
          </p:nvSpPr>
          <p:spPr>
            <a:xfrm>
              <a:off x="532681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9707908-0A34-4865-95CD-B2A02E03952E}"/>
                </a:ext>
              </a:extLst>
            </p:cNvPr>
            <p:cNvSpPr txBox="1"/>
            <p:nvPr/>
          </p:nvSpPr>
          <p:spPr>
            <a:xfrm>
              <a:off x="551858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980859F-3F5D-4164-AF95-0D0D87C146D8}"/>
                </a:ext>
              </a:extLst>
            </p:cNvPr>
            <p:cNvSpPr txBox="1"/>
            <p:nvPr/>
          </p:nvSpPr>
          <p:spPr>
            <a:xfrm>
              <a:off x="566862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16742F1-60F0-417B-AB9B-010564097C42}"/>
                </a:ext>
              </a:extLst>
            </p:cNvPr>
            <p:cNvSpPr txBox="1"/>
            <p:nvPr/>
          </p:nvSpPr>
          <p:spPr>
            <a:xfrm>
              <a:off x="583608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B7D2D0E-0826-42A4-A6C0-D8E28DC3FE54}"/>
                </a:ext>
              </a:extLst>
            </p:cNvPr>
            <p:cNvSpPr txBox="1"/>
            <p:nvPr/>
          </p:nvSpPr>
          <p:spPr>
            <a:xfrm>
              <a:off x="605216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3B3DBBC-D7B5-40F6-BFE7-27C5A1ACF952}"/>
                </a:ext>
              </a:extLst>
            </p:cNvPr>
            <p:cNvSpPr txBox="1"/>
            <p:nvPr/>
          </p:nvSpPr>
          <p:spPr>
            <a:xfrm>
              <a:off x="627818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42E2FA0-DD62-4C89-B626-EBFB3BC65BEF}"/>
                </a:ext>
              </a:extLst>
            </p:cNvPr>
            <p:cNvSpPr txBox="1"/>
            <p:nvPr/>
          </p:nvSpPr>
          <p:spPr>
            <a:xfrm>
              <a:off x="648159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5D0432B-CAA1-4D7F-AA1F-4FE8A39E4558}"/>
                </a:ext>
              </a:extLst>
            </p:cNvPr>
            <p:cNvSpPr txBox="1"/>
            <p:nvPr/>
          </p:nvSpPr>
          <p:spPr>
            <a:xfrm>
              <a:off x="666324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533E214-80FC-42E2-A9CB-9E926C666B6E}"/>
                </a:ext>
              </a:extLst>
            </p:cNvPr>
            <p:cNvSpPr txBox="1"/>
            <p:nvPr/>
          </p:nvSpPr>
          <p:spPr>
            <a:xfrm>
              <a:off x="6830699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464ED37-18FD-4819-8F01-A0C9471E2CA3}"/>
                </a:ext>
              </a:extLst>
            </p:cNvPr>
            <p:cNvSpPr txBox="1"/>
            <p:nvPr/>
          </p:nvSpPr>
          <p:spPr>
            <a:xfrm>
              <a:off x="696332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07B7BFE-11AB-4ED6-A094-3908C71EC566}"/>
                </a:ext>
              </a:extLst>
            </p:cNvPr>
            <p:cNvSpPr txBox="1"/>
            <p:nvPr/>
          </p:nvSpPr>
          <p:spPr>
            <a:xfrm>
              <a:off x="710315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7B8A0B1-00D6-43AA-A9CD-F627A710451F}"/>
                </a:ext>
              </a:extLst>
            </p:cNvPr>
            <p:cNvSpPr txBox="1"/>
            <p:nvPr/>
          </p:nvSpPr>
          <p:spPr>
            <a:xfrm>
              <a:off x="7315603" y="200297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82B78D83-0EDA-40C0-BFCA-02FC90CE345C}"/>
              </a:ext>
            </a:extLst>
          </p:cNvPr>
          <p:cNvGrpSpPr/>
          <p:nvPr/>
        </p:nvGrpSpPr>
        <p:grpSpPr>
          <a:xfrm>
            <a:off x="1375213" y="80755"/>
            <a:ext cx="505383" cy="2038649"/>
            <a:chOff x="1375213" y="80755"/>
            <a:chExt cx="505383" cy="2038649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B653E171-017B-4759-A9F8-85A06E6D9BF9}"/>
                </a:ext>
              </a:extLst>
            </p:cNvPr>
            <p:cNvSpPr txBox="1"/>
            <p:nvPr/>
          </p:nvSpPr>
          <p:spPr>
            <a:xfrm>
              <a:off x="1638222" y="190396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A1E2336-9383-4B0E-B4BA-B7C51E1B576F}"/>
                </a:ext>
              </a:extLst>
            </p:cNvPr>
            <p:cNvSpPr txBox="1"/>
            <p:nvPr/>
          </p:nvSpPr>
          <p:spPr>
            <a:xfrm>
              <a:off x="1638222" y="141582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F7B3306-3232-4BA0-923D-24FC15E4699B}"/>
                </a:ext>
              </a:extLst>
            </p:cNvPr>
            <p:cNvSpPr txBox="1"/>
            <p:nvPr/>
          </p:nvSpPr>
          <p:spPr>
            <a:xfrm>
              <a:off x="1638222" y="92769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82A6090-EEE0-454E-A155-DCE2DFE0CF9C}"/>
                </a:ext>
              </a:extLst>
            </p:cNvPr>
            <p:cNvSpPr txBox="1"/>
            <p:nvPr/>
          </p:nvSpPr>
          <p:spPr>
            <a:xfrm>
              <a:off x="1638222" y="43956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18C20A9-3790-47DA-859D-3F67546EF933}"/>
                </a:ext>
              </a:extLst>
            </p:cNvPr>
            <p:cNvSpPr txBox="1"/>
            <p:nvPr/>
          </p:nvSpPr>
          <p:spPr>
            <a:xfrm rot="10800000">
              <a:off x="1375213" y="812779"/>
              <a:ext cx="353943" cy="81849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100" dirty="0"/>
                <a:t>-log(p-value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42DD186-C2E5-4BF5-9CC4-E9B2BFF292AD}"/>
                </a:ext>
              </a:extLst>
            </p:cNvPr>
            <p:cNvSpPr txBox="1"/>
            <p:nvPr/>
          </p:nvSpPr>
          <p:spPr>
            <a:xfrm>
              <a:off x="1412562" y="80755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E3D0D9C5-6FB5-47B4-9C48-17339A708872}"/>
              </a:ext>
            </a:extLst>
          </p:cNvPr>
          <p:cNvGrpSpPr/>
          <p:nvPr/>
        </p:nvGrpSpPr>
        <p:grpSpPr>
          <a:xfrm>
            <a:off x="1370368" y="2265247"/>
            <a:ext cx="505383" cy="2081041"/>
            <a:chOff x="1375213" y="80755"/>
            <a:chExt cx="505383" cy="2081041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217ECE9-61D6-4BBE-B665-37B15265480B}"/>
                </a:ext>
              </a:extLst>
            </p:cNvPr>
            <p:cNvSpPr txBox="1"/>
            <p:nvPr/>
          </p:nvSpPr>
          <p:spPr>
            <a:xfrm>
              <a:off x="1638222" y="194635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B55C0E4-185A-4439-A7EF-65CB3E7867CF}"/>
                </a:ext>
              </a:extLst>
            </p:cNvPr>
            <p:cNvSpPr txBox="1"/>
            <p:nvPr/>
          </p:nvSpPr>
          <p:spPr>
            <a:xfrm>
              <a:off x="1638222" y="144610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661F41A-6E6B-4358-A625-17AC90ED3898}"/>
                </a:ext>
              </a:extLst>
            </p:cNvPr>
            <p:cNvSpPr txBox="1"/>
            <p:nvPr/>
          </p:nvSpPr>
          <p:spPr>
            <a:xfrm>
              <a:off x="1638222" y="94586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CBBAF8B-4B90-4A8D-BCA4-09B267BD3528}"/>
                </a:ext>
              </a:extLst>
            </p:cNvPr>
            <p:cNvSpPr txBox="1"/>
            <p:nvPr/>
          </p:nvSpPr>
          <p:spPr>
            <a:xfrm>
              <a:off x="1638222" y="43351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18B05B8-C1AA-4A81-92EA-D12C7970116B}"/>
                </a:ext>
              </a:extLst>
            </p:cNvPr>
            <p:cNvSpPr txBox="1"/>
            <p:nvPr/>
          </p:nvSpPr>
          <p:spPr>
            <a:xfrm rot="10800000">
              <a:off x="1375213" y="812779"/>
              <a:ext cx="353943" cy="81849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100" dirty="0"/>
                <a:t>-log(p-value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73B5879-B0DD-4E60-9CF8-0C06AD7D68DD}"/>
                </a:ext>
              </a:extLst>
            </p:cNvPr>
            <p:cNvSpPr txBox="1"/>
            <p:nvPr/>
          </p:nvSpPr>
          <p:spPr>
            <a:xfrm>
              <a:off x="1412562" y="80755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AD71EC1F-F97C-4A3D-BF5B-006BF07AE50C}"/>
              </a:ext>
            </a:extLst>
          </p:cNvPr>
          <p:cNvGrpSpPr/>
          <p:nvPr/>
        </p:nvGrpSpPr>
        <p:grpSpPr>
          <a:xfrm>
            <a:off x="2273089" y="4235238"/>
            <a:ext cx="5321988" cy="215444"/>
            <a:chOff x="2275966" y="2002973"/>
            <a:chExt cx="5321988" cy="215444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C06C364-24F8-4E99-B8A0-C7C2B5AA0367}"/>
                </a:ext>
              </a:extLst>
            </p:cNvPr>
            <p:cNvSpPr txBox="1"/>
            <p:nvPr/>
          </p:nvSpPr>
          <p:spPr>
            <a:xfrm>
              <a:off x="2275966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5AA20FE-1607-49BD-A777-ECFA954A37DF}"/>
                </a:ext>
              </a:extLst>
            </p:cNvPr>
            <p:cNvSpPr txBox="1"/>
            <p:nvPr/>
          </p:nvSpPr>
          <p:spPr>
            <a:xfrm>
              <a:off x="2826902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89E945F-5419-4C85-B61E-749B62D93572}"/>
                </a:ext>
              </a:extLst>
            </p:cNvPr>
            <p:cNvSpPr txBox="1"/>
            <p:nvPr/>
          </p:nvSpPr>
          <p:spPr>
            <a:xfrm>
              <a:off x="326536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F5507BA-AA7C-46F7-9031-E7C8E73413F3}"/>
                </a:ext>
              </a:extLst>
            </p:cNvPr>
            <p:cNvSpPr txBox="1"/>
            <p:nvPr/>
          </p:nvSpPr>
          <p:spPr>
            <a:xfrm>
              <a:off x="362913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8094C68-61D7-42FB-B709-7A94DE117376}"/>
                </a:ext>
              </a:extLst>
            </p:cNvPr>
            <p:cNvSpPr txBox="1"/>
            <p:nvPr/>
          </p:nvSpPr>
          <p:spPr>
            <a:xfrm>
              <a:off x="398853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A23836A-78B1-4F7E-BB0E-71EBF8F5BF44}"/>
                </a:ext>
              </a:extLst>
            </p:cNvPr>
            <p:cNvSpPr txBox="1"/>
            <p:nvPr/>
          </p:nvSpPr>
          <p:spPr>
            <a:xfrm>
              <a:off x="430802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69C6F41-76B4-4C3D-8F75-66392F0355DF}"/>
                </a:ext>
              </a:extLst>
            </p:cNvPr>
            <p:cNvSpPr txBox="1"/>
            <p:nvPr/>
          </p:nvSpPr>
          <p:spPr>
            <a:xfrm>
              <a:off x="4595451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4C18C23-6039-4BAA-8F5A-E0E96FAA6E5F}"/>
                </a:ext>
              </a:extLst>
            </p:cNvPr>
            <p:cNvSpPr txBox="1"/>
            <p:nvPr/>
          </p:nvSpPr>
          <p:spPr>
            <a:xfrm>
              <a:off x="4868257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B1852E7-1394-40ED-B374-4C92475D822C}"/>
                </a:ext>
              </a:extLst>
            </p:cNvPr>
            <p:cNvSpPr txBox="1"/>
            <p:nvPr/>
          </p:nvSpPr>
          <p:spPr>
            <a:xfrm>
              <a:off x="512376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5927BDD-B777-4001-99CC-0CDE0398AF10}"/>
                </a:ext>
              </a:extLst>
            </p:cNvPr>
            <p:cNvSpPr txBox="1"/>
            <p:nvPr/>
          </p:nvSpPr>
          <p:spPr>
            <a:xfrm>
              <a:off x="532681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636DA12-4295-4A89-8308-9B1929E7DACA}"/>
                </a:ext>
              </a:extLst>
            </p:cNvPr>
            <p:cNvSpPr txBox="1"/>
            <p:nvPr/>
          </p:nvSpPr>
          <p:spPr>
            <a:xfrm>
              <a:off x="552433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0056F77-4002-468E-AED9-7B5F388405DC}"/>
                </a:ext>
              </a:extLst>
            </p:cNvPr>
            <p:cNvSpPr txBox="1"/>
            <p:nvPr/>
          </p:nvSpPr>
          <p:spPr>
            <a:xfrm>
              <a:off x="566862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8CE9695-7126-4DD0-B742-57BF31515D1F}"/>
                </a:ext>
              </a:extLst>
            </p:cNvPr>
            <p:cNvSpPr txBox="1"/>
            <p:nvPr/>
          </p:nvSpPr>
          <p:spPr>
            <a:xfrm>
              <a:off x="585909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5DCDDE0-D0BB-457D-9E87-6AFC1B4D5D87}"/>
                </a:ext>
              </a:extLst>
            </p:cNvPr>
            <p:cNvSpPr txBox="1"/>
            <p:nvPr/>
          </p:nvSpPr>
          <p:spPr>
            <a:xfrm>
              <a:off x="606366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7CC552AE-9565-4C30-9A77-708D2B418711}"/>
                </a:ext>
              </a:extLst>
            </p:cNvPr>
            <p:cNvSpPr txBox="1"/>
            <p:nvPr/>
          </p:nvSpPr>
          <p:spPr>
            <a:xfrm>
              <a:off x="6289689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FF78704-BC53-4B42-B8BB-43BA8DC7607F}"/>
                </a:ext>
              </a:extLst>
            </p:cNvPr>
            <p:cNvSpPr txBox="1"/>
            <p:nvPr/>
          </p:nvSpPr>
          <p:spPr>
            <a:xfrm>
              <a:off x="648159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BFBEA95-F326-471A-B4DC-A6D3AAE4D388}"/>
                </a:ext>
              </a:extLst>
            </p:cNvPr>
            <p:cNvSpPr txBox="1"/>
            <p:nvPr/>
          </p:nvSpPr>
          <p:spPr>
            <a:xfrm>
              <a:off x="666324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00AFCEFA-4052-46D9-897E-1ED8C0697F88}"/>
                </a:ext>
              </a:extLst>
            </p:cNvPr>
            <p:cNvSpPr txBox="1"/>
            <p:nvPr/>
          </p:nvSpPr>
          <p:spPr>
            <a:xfrm>
              <a:off x="683645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E83963D-457D-40EA-A2F9-F3B08F24A768}"/>
                </a:ext>
              </a:extLst>
            </p:cNvPr>
            <p:cNvSpPr txBox="1"/>
            <p:nvPr/>
          </p:nvSpPr>
          <p:spPr>
            <a:xfrm>
              <a:off x="698632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C2BD47C-6D20-4660-88A5-529CC336E2C1}"/>
                </a:ext>
              </a:extLst>
            </p:cNvPr>
            <p:cNvSpPr txBox="1"/>
            <p:nvPr/>
          </p:nvSpPr>
          <p:spPr>
            <a:xfrm>
              <a:off x="712616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ED66A0A-D6A3-4C87-B6A2-1AA9B951B418}"/>
                </a:ext>
              </a:extLst>
            </p:cNvPr>
            <p:cNvSpPr txBox="1"/>
            <p:nvPr/>
          </p:nvSpPr>
          <p:spPr>
            <a:xfrm>
              <a:off x="7344358" y="200297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B1F8BD26-91D3-4385-B156-B7E0FDB160AE}"/>
              </a:ext>
            </a:extLst>
          </p:cNvPr>
          <p:cNvGrpSpPr/>
          <p:nvPr/>
        </p:nvGrpSpPr>
        <p:grpSpPr>
          <a:xfrm>
            <a:off x="1370368" y="4549919"/>
            <a:ext cx="505383" cy="2081041"/>
            <a:chOff x="1375213" y="80755"/>
            <a:chExt cx="505383" cy="2081041"/>
          </a:xfrm>
        </p:grpSpPr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15614C39-2A1E-49A3-9152-70C06D87944C}"/>
                </a:ext>
              </a:extLst>
            </p:cNvPr>
            <p:cNvSpPr txBox="1"/>
            <p:nvPr/>
          </p:nvSpPr>
          <p:spPr>
            <a:xfrm>
              <a:off x="1638222" y="194635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77C03DB6-06FF-466F-BB10-258AD1816287}"/>
                </a:ext>
              </a:extLst>
            </p:cNvPr>
            <p:cNvSpPr txBox="1"/>
            <p:nvPr/>
          </p:nvSpPr>
          <p:spPr>
            <a:xfrm>
              <a:off x="1638222" y="1446109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E1AC65DD-80C4-43B9-A5B5-E9299E9FEC5C}"/>
                </a:ext>
              </a:extLst>
            </p:cNvPr>
            <p:cNvSpPr txBox="1"/>
            <p:nvPr/>
          </p:nvSpPr>
          <p:spPr>
            <a:xfrm>
              <a:off x="1638222" y="94586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DB80C0B-E31D-4E7A-8295-FC4065550635}"/>
                </a:ext>
              </a:extLst>
            </p:cNvPr>
            <p:cNvSpPr txBox="1"/>
            <p:nvPr/>
          </p:nvSpPr>
          <p:spPr>
            <a:xfrm>
              <a:off x="1638222" y="43351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002338C9-A5B6-404C-872F-BA844D1CDBC9}"/>
                </a:ext>
              </a:extLst>
            </p:cNvPr>
            <p:cNvSpPr txBox="1"/>
            <p:nvPr/>
          </p:nvSpPr>
          <p:spPr>
            <a:xfrm rot="10800000">
              <a:off x="1375213" y="812779"/>
              <a:ext cx="353943" cy="81849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100" dirty="0"/>
                <a:t>-log(p-value)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075553E3-0C3B-4E0E-9447-0300D2643994}"/>
                </a:ext>
              </a:extLst>
            </p:cNvPr>
            <p:cNvSpPr txBox="1"/>
            <p:nvPr/>
          </p:nvSpPr>
          <p:spPr>
            <a:xfrm>
              <a:off x="1412562" y="80755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A8586CEE-FD31-4320-9F42-DBC19621E631}"/>
              </a:ext>
            </a:extLst>
          </p:cNvPr>
          <p:cNvGrpSpPr/>
          <p:nvPr/>
        </p:nvGrpSpPr>
        <p:grpSpPr>
          <a:xfrm>
            <a:off x="2279105" y="6509398"/>
            <a:ext cx="5321988" cy="215444"/>
            <a:chOff x="2281982" y="2002973"/>
            <a:chExt cx="5321988" cy="215444"/>
          </a:xfrm>
        </p:grpSpPr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A172B684-258C-433F-BE95-4E4A7A011608}"/>
                </a:ext>
              </a:extLst>
            </p:cNvPr>
            <p:cNvSpPr txBox="1"/>
            <p:nvPr/>
          </p:nvSpPr>
          <p:spPr>
            <a:xfrm>
              <a:off x="2281982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FF52EE68-7C98-4735-A57B-09CC4DB34732}"/>
                </a:ext>
              </a:extLst>
            </p:cNvPr>
            <p:cNvSpPr txBox="1"/>
            <p:nvPr/>
          </p:nvSpPr>
          <p:spPr>
            <a:xfrm>
              <a:off x="2832918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54199ED2-251C-4499-88EF-DE7E2F100F1B}"/>
                </a:ext>
              </a:extLst>
            </p:cNvPr>
            <p:cNvSpPr txBox="1"/>
            <p:nvPr/>
          </p:nvSpPr>
          <p:spPr>
            <a:xfrm>
              <a:off x="3277392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4B0CF29-980A-4C3A-804E-D9C89FC3FA16}"/>
                </a:ext>
              </a:extLst>
            </p:cNvPr>
            <p:cNvSpPr txBox="1"/>
            <p:nvPr/>
          </p:nvSpPr>
          <p:spPr>
            <a:xfrm>
              <a:off x="363515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25A4C1CB-5887-4F3B-8FEC-C5196B64EE04}"/>
                </a:ext>
              </a:extLst>
            </p:cNvPr>
            <p:cNvSpPr txBox="1"/>
            <p:nvPr/>
          </p:nvSpPr>
          <p:spPr>
            <a:xfrm>
              <a:off x="399455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F769E657-AFBB-4B8F-89BB-03F189DB3C03}"/>
                </a:ext>
              </a:extLst>
            </p:cNvPr>
            <p:cNvSpPr txBox="1"/>
            <p:nvPr/>
          </p:nvSpPr>
          <p:spPr>
            <a:xfrm>
              <a:off x="4314036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FE33F0B-BCAF-49CF-B0C5-83283733B558}"/>
                </a:ext>
              </a:extLst>
            </p:cNvPr>
            <p:cNvSpPr txBox="1"/>
            <p:nvPr/>
          </p:nvSpPr>
          <p:spPr>
            <a:xfrm>
              <a:off x="4601467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4380E5BE-FD8B-4609-8AC4-06AA5277D896}"/>
                </a:ext>
              </a:extLst>
            </p:cNvPr>
            <p:cNvSpPr txBox="1"/>
            <p:nvPr/>
          </p:nvSpPr>
          <p:spPr>
            <a:xfrm>
              <a:off x="4880289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B7555BCA-3DEE-45E5-A590-9692ED96E33A}"/>
                </a:ext>
              </a:extLst>
            </p:cNvPr>
            <p:cNvSpPr txBox="1"/>
            <p:nvPr/>
          </p:nvSpPr>
          <p:spPr>
            <a:xfrm>
              <a:off x="512978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62A313BB-B49C-41EE-A6AC-6D966575C510}"/>
                </a:ext>
              </a:extLst>
            </p:cNvPr>
            <p:cNvSpPr txBox="1"/>
            <p:nvPr/>
          </p:nvSpPr>
          <p:spPr>
            <a:xfrm>
              <a:off x="532681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E58FCA5C-3A08-4B4A-B099-8B14BE0D9BFB}"/>
                </a:ext>
              </a:extLst>
            </p:cNvPr>
            <p:cNvSpPr txBox="1"/>
            <p:nvPr/>
          </p:nvSpPr>
          <p:spPr>
            <a:xfrm>
              <a:off x="5530353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3384E1F1-E9BA-4319-80C6-3E837AF476F4}"/>
                </a:ext>
              </a:extLst>
            </p:cNvPr>
            <p:cNvSpPr txBox="1"/>
            <p:nvPr/>
          </p:nvSpPr>
          <p:spPr>
            <a:xfrm>
              <a:off x="5674643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C1E19951-A9A4-4DFC-A655-11F225729500}"/>
                </a:ext>
              </a:extLst>
            </p:cNvPr>
            <p:cNvSpPr txBox="1"/>
            <p:nvPr/>
          </p:nvSpPr>
          <p:spPr>
            <a:xfrm>
              <a:off x="5847058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101E4F21-5DCF-419C-9AB0-8BD18006AC60}"/>
                </a:ext>
              </a:extLst>
            </p:cNvPr>
            <p:cNvSpPr txBox="1"/>
            <p:nvPr/>
          </p:nvSpPr>
          <p:spPr>
            <a:xfrm>
              <a:off x="606366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E53AF53-448A-44FB-92E3-464A0B07EAFB}"/>
                </a:ext>
              </a:extLst>
            </p:cNvPr>
            <p:cNvSpPr txBox="1"/>
            <p:nvPr/>
          </p:nvSpPr>
          <p:spPr>
            <a:xfrm>
              <a:off x="6289689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972B8FBC-7F66-4D20-B6EA-3B897FEDA72B}"/>
                </a:ext>
              </a:extLst>
            </p:cNvPr>
            <p:cNvSpPr txBox="1"/>
            <p:nvPr/>
          </p:nvSpPr>
          <p:spPr>
            <a:xfrm>
              <a:off x="6487608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65268CFD-EEA7-4A8B-9FD8-B9760153CB4B}"/>
                </a:ext>
              </a:extLst>
            </p:cNvPr>
            <p:cNvSpPr txBox="1"/>
            <p:nvPr/>
          </p:nvSpPr>
          <p:spPr>
            <a:xfrm>
              <a:off x="666925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9967A5E6-1654-4859-BFAF-1F8A7713A648}"/>
                </a:ext>
              </a:extLst>
            </p:cNvPr>
            <p:cNvSpPr txBox="1"/>
            <p:nvPr/>
          </p:nvSpPr>
          <p:spPr>
            <a:xfrm>
              <a:off x="683645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395204AA-5E3C-4476-AD1B-5CA7B6E23D17}"/>
                </a:ext>
              </a:extLst>
            </p:cNvPr>
            <p:cNvSpPr txBox="1"/>
            <p:nvPr/>
          </p:nvSpPr>
          <p:spPr>
            <a:xfrm>
              <a:off x="698632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1BC46CC8-8AC7-4DBF-B27F-41C8FDF43A72}"/>
                </a:ext>
              </a:extLst>
            </p:cNvPr>
            <p:cNvSpPr txBox="1"/>
            <p:nvPr/>
          </p:nvSpPr>
          <p:spPr>
            <a:xfrm>
              <a:off x="712616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8C4F2E39-91CA-485C-904F-0E230AC3C281}"/>
                </a:ext>
              </a:extLst>
            </p:cNvPr>
            <p:cNvSpPr txBox="1"/>
            <p:nvPr/>
          </p:nvSpPr>
          <p:spPr>
            <a:xfrm>
              <a:off x="7350374" y="200297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E2E0C1A2-545F-4873-A835-0664E0CAD3AC}"/>
              </a:ext>
            </a:extLst>
          </p:cNvPr>
          <p:cNvSpPr txBox="1"/>
          <p:nvPr/>
        </p:nvSpPr>
        <p:spPr>
          <a:xfrm>
            <a:off x="4362440" y="2090801"/>
            <a:ext cx="9541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hromosome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77EAC4B-7052-4D6F-9736-19959742CD11}"/>
              </a:ext>
            </a:extLst>
          </p:cNvPr>
          <p:cNvSpPr txBox="1"/>
          <p:nvPr/>
        </p:nvSpPr>
        <p:spPr>
          <a:xfrm>
            <a:off x="4362440" y="4327238"/>
            <a:ext cx="9541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hromosome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7B70E8D-260B-4BE4-862F-39F1A849297D}"/>
              </a:ext>
            </a:extLst>
          </p:cNvPr>
          <p:cNvSpPr txBox="1"/>
          <p:nvPr/>
        </p:nvSpPr>
        <p:spPr>
          <a:xfrm>
            <a:off x="4362650" y="6594188"/>
            <a:ext cx="9541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hromosome</a:t>
            </a:r>
          </a:p>
        </p:txBody>
      </p:sp>
    </p:spTree>
    <p:extLst>
      <p:ext uri="{BB962C8B-B14F-4D97-AF65-F5344CB8AC3E}">
        <p14:creationId xmlns:p14="http://schemas.microsoft.com/office/powerpoint/2010/main" val="8884924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A80041B-F641-436B-9F0A-9B853B5251D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687" t="5406" b="7744"/>
          <a:stretch/>
        </p:blipFill>
        <p:spPr>
          <a:xfrm>
            <a:off x="1813872" y="42713"/>
            <a:ext cx="6103015" cy="1960260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6FC6F9EA-33EF-45D0-A82D-3550C7EA9C6B}"/>
              </a:ext>
            </a:extLst>
          </p:cNvPr>
          <p:cNvGrpSpPr/>
          <p:nvPr/>
        </p:nvGrpSpPr>
        <p:grpSpPr>
          <a:xfrm>
            <a:off x="2275966" y="1966103"/>
            <a:ext cx="5300057" cy="215444"/>
            <a:chOff x="2275966" y="2002973"/>
            <a:chExt cx="5300057" cy="215444"/>
          </a:xfrm>
        </p:grpSpPr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A19BD6A9-01A6-4C69-A401-4AF223AAFA4A}"/>
                </a:ext>
              </a:extLst>
            </p:cNvPr>
            <p:cNvSpPr txBox="1"/>
            <p:nvPr/>
          </p:nvSpPr>
          <p:spPr>
            <a:xfrm>
              <a:off x="2275966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8860C2D-A2DF-48CF-BB78-61756720671F}"/>
                </a:ext>
              </a:extLst>
            </p:cNvPr>
            <p:cNvSpPr txBox="1"/>
            <p:nvPr/>
          </p:nvSpPr>
          <p:spPr>
            <a:xfrm>
              <a:off x="2833726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05CC37A0-24BA-4499-B912-A4CDDD83E0BA}"/>
                </a:ext>
              </a:extLst>
            </p:cNvPr>
            <p:cNvSpPr txBox="1"/>
            <p:nvPr/>
          </p:nvSpPr>
          <p:spPr>
            <a:xfrm>
              <a:off x="3279008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8BE2E8A-EDA4-4B5F-9918-E0BBAB4E58B3}"/>
                </a:ext>
              </a:extLst>
            </p:cNvPr>
            <p:cNvSpPr txBox="1"/>
            <p:nvPr/>
          </p:nvSpPr>
          <p:spPr>
            <a:xfrm>
              <a:off x="3648533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3DF7C57E-59FD-4EB9-8112-568917DA60F8}"/>
                </a:ext>
              </a:extLst>
            </p:cNvPr>
            <p:cNvSpPr txBox="1"/>
            <p:nvPr/>
          </p:nvSpPr>
          <p:spPr>
            <a:xfrm>
              <a:off x="4001109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BAC4277-0DA2-45B9-A048-8C31D58ECADC}"/>
                </a:ext>
              </a:extLst>
            </p:cNvPr>
            <p:cNvSpPr txBox="1"/>
            <p:nvPr/>
          </p:nvSpPr>
          <p:spPr>
            <a:xfrm>
              <a:off x="4327419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758508A-EDAA-40B9-B99C-C6B59D8D32AA}"/>
                </a:ext>
              </a:extLst>
            </p:cNvPr>
            <p:cNvSpPr txBox="1"/>
            <p:nvPr/>
          </p:nvSpPr>
          <p:spPr>
            <a:xfrm>
              <a:off x="4620601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31DEA9A-2353-45F1-BCC9-ACC7638D4F11}"/>
                </a:ext>
              </a:extLst>
            </p:cNvPr>
            <p:cNvSpPr txBox="1"/>
            <p:nvPr/>
          </p:nvSpPr>
          <p:spPr>
            <a:xfrm>
              <a:off x="490130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D054BA0A-2D11-4A71-917F-BBEB44CDF290}"/>
                </a:ext>
              </a:extLst>
            </p:cNvPr>
            <p:cNvSpPr txBox="1"/>
            <p:nvPr/>
          </p:nvSpPr>
          <p:spPr>
            <a:xfrm>
              <a:off x="515788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EB08545-2BC9-4109-A742-22D5F4040E52}"/>
                </a:ext>
              </a:extLst>
            </p:cNvPr>
            <p:cNvSpPr txBox="1"/>
            <p:nvPr/>
          </p:nvSpPr>
          <p:spPr>
            <a:xfrm>
              <a:off x="5354113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9707908-0A34-4865-95CD-B2A02E03952E}"/>
                </a:ext>
              </a:extLst>
            </p:cNvPr>
            <p:cNvSpPr txBox="1"/>
            <p:nvPr/>
          </p:nvSpPr>
          <p:spPr>
            <a:xfrm>
              <a:off x="5566354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980859F-3F5D-4164-AF95-0D0D87C146D8}"/>
                </a:ext>
              </a:extLst>
            </p:cNvPr>
            <p:cNvSpPr txBox="1"/>
            <p:nvPr/>
          </p:nvSpPr>
          <p:spPr>
            <a:xfrm>
              <a:off x="5709571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16742F1-60F0-417B-AB9B-010564097C42}"/>
                </a:ext>
              </a:extLst>
            </p:cNvPr>
            <p:cNvSpPr txBox="1"/>
            <p:nvPr/>
          </p:nvSpPr>
          <p:spPr>
            <a:xfrm>
              <a:off x="5863382" y="2002973"/>
              <a:ext cx="3000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B7D2D0E-0826-42A4-A6C0-D8E28DC3FE54}"/>
                </a:ext>
              </a:extLst>
            </p:cNvPr>
            <p:cNvSpPr txBox="1"/>
            <p:nvPr/>
          </p:nvSpPr>
          <p:spPr>
            <a:xfrm>
              <a:off x="607263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E3B3DBBC-D7B5-40F6-BFE7-27C5A1ACF952}"/>
                </a:ext>
              </a:extLst>
            </p:cNvPr>
            <p:cNvSpPr txBox="1"/>
            <p:nvPr/>
          </p:nvSpPr>
          <p:spPr>
            <a:xfrm>
              <a:off x="6298659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42E2FA0-DD62-4C89-B626-EBFB3BC65BEF}"/>
                </a:ext>
              </a:extLst>
            </p:cNvPr>
            <p:cNvSpPr txBox="1"/>
            <p:nvPr/>
          </p:nvSpPr>
          <p:spPr>
            <a:xfrm>
              <a:off x="6502064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5D0432B-CAA1-4D7F-AA1F-4FE8A39E4558}"/>
                </a:ext>
              </a:extLst>
            </p:cNvPr>
            <p:cNvSpPr txBox="1"/>
            <p:nvPr/>
          </p:nvSpPr>
          <p:spPr>
            <a:xfrm>
              <a:off x="668371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533E214-80FC-42E2-A9CB-9E926C666B6E}"/>
                </a:ext>
              </a:extLst>
            </p:cNvPr>
            <p:cNvSpPr txBox="1"/>
            <p:nvPr/>
          </p:nvSpPr>
          <p:spPr>
            <a:xfrm>
              <a:off x="684434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464ED37-18FD-4819-8F01-A0C9471E2CA3}"/>
                </a:ext>
              </a:extLst>
            </p:cNvPr>
            <p:cNvSpPr txBox="1"/>
            <p:nvPr/>
          </p:nvSpPr>
          <p:spPr>
            <a:xfrm>
              <a:off x="697697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07B7BFE-11AB-4ED6-A094-3908C71EC566}"/>
                </a:ext>
              </a:extLst>
            </p:cNvPr>
            <p:cNvSpPr txBox="1"/>
            <p:nvPr/>
          </p:nvSpPr>
          <p:spPr>
            <a:xfrm>
              <a:off x="710998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7B8A0B1-00D6-43AA-A9CD-F627A710451F}"/>
                </a:ext>
              </a:extLst>
            </p:cNvPr>
            <p:cNvSpPr txBox="1"/>
            <p:nvPr/>
          </p:nvSpPr>
          <p:spPr>
            <a:xfrm>
              <a:off x="7322427" y="200297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grpSp>
        <p:nvGrpSpPr>
          <p:cNvPr id="9" name="Group 8">
            <a:extLst>
              <a:ext uri="{FF2B5EF4-FFF2-40B4-BE49-F238E27FC236}">
                <a16:creationId xmlns:a16="http://schemas.microsoft.com/office/drawing/2014/main" id="{82B78D83-0EDA-40C0-BFCA-02FC90CE345C}"/>
              </a:ext>
            </a:extLst>
          </p:cNvPr>
          <p:cNvGrpSpPr/>
          <p:nvPr/>
        </p:nvGrpSpPr>
        <p:grpSpPr>
          <a:xfrm>
            <a:off x="1101162" y="20067"/>
            <a:ext cx="789353" cy="1658831"/>
            <a:chOff x="1101162" y="20067"/>
            <a:chExt cx="789353" cy="1658831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7A1E2336-9383-4B0E-B4BA-B7C51E1B576F}"/>
                </a:ext>
              </a:extLst>
            </p:cNvPr>
            <p:cNvSpPr txBox="1"/>
            <p:nvPr/>
          </p:nvSpPr>
          <p:spPr>
            <a:xfrm>
              <a:off x="1552497" y="1463454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F7B3306-3232-4BA0-923D-24FC15E4699B}"/>
                </a:ext>
              </a:extLst>
            </p:cNvPr>
            <p:cNvSpPr txBox="1"/>
            <p:nvPr/>
          </p:nvSpPr>
          <p:spPr>
            <a:xfrm>
              <a:off x="1561579" y="1014260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.0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82A6090-EEE0-454E-A155-DCE2DFE0CF9C}"/>
                </a:ext>
              </a:extLst>
            </p:cNvPr>
            <p:cNvSpPr txBox="1"/>
            <p:nvPr/>
          </p:nvSpPr>
          <p:spPr>
            <a:xfrm>
              <a:off x="1561579" y="562546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.5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18C20A9-3790-47DA-859D-3F67546EF933}"/>
                </a:ext>
              </a:extLst>
            </p:cNvPr>
            <p:cNvSpPr txBox="1"/>
            <p:nvPr/>
          </p:nvSpPr>
          <p:spPr>
            <a:xfrm rot="10800000">
              <a:off x="1273038" y="712735"/>
              <a:ext cx="353943" cy="81849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100" dirty="0"/>
                <a:t>-log(p-value)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B42DD186-C2E5-4BF5-9CC4-E9B2BFF292AD}"/>
                </a:ext>
              </a:extLst>
            </p:cNvPr>
            <p:cNvSpPr txBox="1"/>
            <p:nvPr/>
          </p:nvSpPr>
          <p:spPr>
            <a:xfrm>
              <a:off x="1101162" y="20067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E3D0D9C5-6FB5-47B4-9C48-17339A708872}"/>
              </a:ext>
            </a:extLst>
          </p:cNvPr>
          <p:cNvGrpSpPr/>
          <p:nvPr/>
        </p:nvGrpSpPr>
        <p:grpSpPr>
          <a:xfrm>
            <a:off x="1101162" y="2224088"/>
            <a:ext cx="774589" cy="1705783"/>
            <a:chOff x="1106007" y="77696"/>
            <a:chExt cx="774589" cy="1705783"/>
          </a:xfrm>
        </p:grpSpPr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B55C0E4-185A-4439-A7EF-65CB3E7867CF}"/>
                </a:ext>
              </a:extLst>
            </p:cNvPr>
            <p:cNvSpPr txBox="1"/>
            <p:nvPr/>
          </p:nvSpPr>
          <p:spPr>
            <a:xfrm>
              <a:off x="1638222" y="156803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C661F41A-6E6B-4358-A625-17AC90ED3898}"/>
                </a:ext>
              </a:extLst>
            </p:cNvPr>
            <p:cNvSpPr txBox="1"/>
            <p:nvPr/>
          </p:nvSpPr>
          <p:spPr>
            <a:xfrm>
              <a:off x="1638222" y="105037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4CBBAF8B-4B90-4A8D-BCA4-09B267BD3528}"/>
                </a:ext>
              </a:extLst>
            </p:cNvPr>
            <p:cNvSpPr txBox="1"/>
            <p:nvPr/>
          </p:nvSpPr>
          <p:spPr>
            <a:xfrm>
              <a:off x="1638222" y="55543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18B05B8-C1AA-4A81-92EA-D12C7970116B}"/>
                </a:ext>
              </a:extLst>
            </p:cNvPr>
            <p:cNvSpPr txBox="1"/>
            <p:nvPr/>
          </p:nvSpPr>
          <p:spPr>
            <a:xfrm rot="10800000">
              <a:off x="1277883" y="768481"/>
              <a:ext cx="353943" cy="81849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100" dirty="0"/>
                <a:t>-log(p-value)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673B5879-B0DD-4E60-9CF8-0C06AD7D68DD}"/>
                </a:ext>
              </a:extLst>
            </p:cNvPr>
            <p:cNvSpPr txBox="1"/>
            <p:nvPr/>
          </p:nvSpPr>
          <p:spPr>
            <a:xfrm>
              <a:off x="1106007" y="77696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  <p:grpSp>
        <p:nvGrpSpPr>
          <p:cNvPr id="48" name="Group 47">
            <a:extLst>
              <a:ext uri="{FF2B5EF4-FFF2-40B4-BE49-F238E27FC236}">
                <a16:creationId xmlns:a16="http://schemas.microsoft.com/office/drawing/2014/main" id="{AD71EC1F-F97C-4A3D-BF5B-006BF07AE50C}"/>
              </a:ext>
            </a:extLst>
          </p:cNvPr>
          <p:cNvGrpSpPr/>
          <p:nvPr/>
        </p:nvGrpSpPr>
        <p:grpSpPr>
          <a:xfrm>
            <a:off x="2266739" y="4197138"/>
            <a:ext cx="5315638" cy="215444"/>
            <a:chOff x="2275966" y="2002973"/>
            <a:chExt cx="5315638" cy="215444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C06C364-24F8-4E99-B8A0-C7C2B5AA0367}"/>
                </a:ext>
              </a:extLst>
            </p:cNvPr>
            <p:cNvSpPr txBox="1"/>
            <p:nvPr/>
          </p:nvSpPr>
          <p:spPr>
            <a:xfrm>
              <a:off x="2275966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B5AA20FE-1607-49BD-A777-ECFA954A37DF}"/>
                </a:ext>
              </a:extLst>
            </p:cNvPr>
            <p:cNvSpPr txBox="1"/>
            <p:nvPr/>
          </p:nvSpPr>
          <p:spPr>
            <a:xfrm>
              <a:off x="2826902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89E945F-5419-4C85-B61E-749B62D93572}"/>
                </a:ext>
              </a:extLst>
            </p:cNvPr>
            <p:cNvSpPr txBox="1"/>
            <p:nvPr/>
          </p:nvSpPr>
          <p:spPr>
            <a:xfrm>
              <a:off x="326536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FF5507BA-AA7C-46F7-9031-E7C8E73413F3}"/>
                </a:ext>
              </a:extLst>
            </p:cNvPr>
            <p:cNvSpPr txBox="1"/>
            <p:nvPr/>
          </p:nvSpPr>
          <p:spPr>
            <a:xfrm>
              <a:off x="362913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38094C68-61D7-42FB-B709-7A94DE117376}"/>
                </a:ext>
              </a:extLst>
            </p:cNvPr>
            <p:cNvSpPr txBox="1"/>
            <p:nvPr/>
          </p:nvSpPr>
          <p:spPr>
            <a:xfrm>
              <a:off x="398853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DA23836A-78B1-4F7E-BB0E-71EBF8F5BF44}"/>
                </a:ext>
              </a:extLst>
            </p:cNvPr>
            <p:cNvSpPr txBox="1"/>
            <p:nvPr/>
          </p:nvSpPr>
          <p:spPr>
            <a:xfrm>
              <a:off x="430802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69C6F41-76B4-4C3D-8F75-66392F0355DF}"/>
                </a:ext>
              </a:extLst>
            </p:cNvPr>
            <p:cNvSpPr txBox="1"/>
            <p:nvPr/>
          </p:nvSpPr>
          <p:spPr>
            <a:xfrm>
              <a:off x="4595451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4C18C23-6039-4BAA-8F5A-E0E96FAA6E5F}"/>
                </a:ext>
              </a:extLst>
            </p:cNvPr>
            <p:cNvSpPr txBox="1"/>
            <p:nvPr/>
          </p:nvSpPr>
          <p:spPr>
            <a:xfrm>
              <a:off x="4868257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DB1852E7-1394-40ED-B374-4C92475D822C}"/>
                </a:ext>
              </a:extLst>
            </p:cNvPr>
            <p:cNvSpPr txBox="1"/>
            <p:nvPr/>
          </p:nvSpPr>
          <p:spPr>
            <a:xfrm>
              <a:off x="512376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5927BDD-B777-4001-99CC-0CDE0398AF10}"/>
                </a:ext>
              </a:extLst>
            </p:cNvPr>
            <p:cNvSpPr txBox="1"/>
            <p:nvPr/>
          </p:nvSpPr>
          <p:spPr>
            <a:xfrm>
              <a:off x="532681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F636DA12-4295-4A89-8308-9B1929E7DACA}"/>
                </a:ext>
              </a:extLst>
            </p:cNvPr>
            <p:cNvSpPr txBox="1"/>
            <p:nvPr/>
          </p:nvSpPr>
          <p:spPr>
            <a:xfrm>
              <a:off x="552433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30056F77-4002-468E-AED9-7B5F388405DC}"/>
                </a:ext>
              </a:extLst>
            </p:cNvPr>
            <p:cNvSpPr txBox="1"/>
            <p:nvPr/>
          </p:nvSpPr>
          <p:spPr>
            <a:xfrm>
              <a:off x="566862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B8CE9695-7126-4DD0-B742-57BF31515D1F}"/>
                </a:ext>
              </a:extLst>
            </p:cNvPr>
            <p:cNvSpPr txBox="1"/>
            <p:nvPr/>
          </p:nvSpPr>
          <p:spPr>
            <a:xfrm>
              <a:off x="585909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B5DCDDE0-D0BB-457D-9E87-6AFC1B4D5D87}"/>
                </a:ext>
              </a:extLst>
            </p:cNvPr>
            <p:cNvSpPr txBox="1"/>
            <p:nvPr/>
          </p:nvSpPr>
          <p:spPr>
            <a:xfrm>
              <a:off x="606366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7CC552AE-9565-4C30-9A77-708D2B418711}"/>
                </a:ext>
              </a:extLst>
            </p:cNvPr>
            <p:cNvSpPr txBox="1"/>
            <p:nvPr/>
          </p:nvSpPr>
          <p:spPr>
            <a:xfrm>
              <a:off x="6289689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FF78704-BC53-4B42-B8BB-43BA8DC7607F}"/>
                </a:ext>
              </a:extLst>
            </p:cNvPr>
            <p:cNvSpPr txBox="1"/>
            <p:nvPr/>
          </p:nvSpPr>
          <p:spPr>
            <a:xfrm>
              <a:off x="648159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8BFBEA95-F326-471A-B4DC-A6D3AAE4D388}"/>
                </a:ext>
              </a:extLst>
            </p:cNvPr>
            <p:cNvSpPr txBox="1"/>
            <p:nvPr/>
          </p:nvSpPr>
          <p:spPr>
            <a:xfrm>
              <a:off x="666324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00AFCEFA-4052-46D9-897E-1ED8C0697F88}"/>
                </a:ext>
              </a:extLst>
            </p:cNvPr>
            <p:cNvSpPr txBox="1"/>
            <p:nvPr/>
          </p:nvSpPr>
          <p:spPr>
            <a:xfrm>
              <a:off x="683645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7E83963D-457D-40EA-A2F9-F3B08F24A768}"/>
                </a:ext>
              </a:extLst>
            </p:cNvPr>
            <p:cNvSpPr txBox="1"/>
            <p:nvPr/>
          </p:nvSpPr>
          <p:spPr>
            <a:xfrm>
              <a:off x="698632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6C2BD47C-6D20-4660-88A5-529CC336E2C1}"/>
                </a:ext>
              </a:extLst>
            </p:cNvPr>
            <p:cNvSpPr txBox="1"/>
            <p:nvPr/>
          </p:nvSpPr>
          <p:spPr>
            <a:xfrm>
              <a:off x="712616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BED66A0A-D6A3-4C87-B6A2-1AA9B951B418}"/>
                </a:ext>
              </a:extLst>
            </p:cNvPr>
            <p:cNvSpPr txBox="1"/>
            <p:nvPr/>
          </p:nvSpPr>
          <p:spPr>
            <a:xfrm>
              <a:off x="7338008" y="200297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E2E0C1A2-545F-4873-A835-0664E0CAD3AC}"/>
              </a:ext>
            </a:extLst>
          </p:cNvPr>
          <p:cNvSpPr txBox="1"/>
          <p:nvPr/>
        </p:nvSpPr>
        <p:spPr>
          <a:xfrm>
            <a:off x="4362440" y="2090801"/>
            <a:ext cx="9541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hromosome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D77EAC4B-7052-4D6F-9736-19959742CD11}"/>
              </a:ext>
            </a:extLst>
          </p:cNvPr>
          <p:cNvSpPr txBox="1"/>
          <p:nvPr/>
        </p:nvSpPr>
        <p:spPr>
          <a:xfrm>
            <a:off x="4362440" y="4336763"/>
            <a:ext cx="9541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hromosome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27B70E8D-260B-4BE4-862F-39F1A849297D}"/>
              </a:ext>
            </a:extLst>
          </p:cNvPr>
          <p:cNvSpPr txBox="1"/>
          <p:nvPr/>
        </p:nvSpPr>
        <p:spPr>
          <a:xfrm>
            <a:off x="4362650" y="6546563"/>
            <a:ext cx="9541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Chromosome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380ED0DD-BA5D-473C-B01B-6BB54F62AF8E}"/>
              </a:ext>
            </a:extLst>
          </p:cNvPr>
          <p:cNvSpPr txBox="1"/>
          <p:nvPr/>
        </p:nvSpPr>
        <p:spPr>
          <a:xfrm>
            <a:off x="1513230" y="11870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0.0</a:t>
            </a:r>
          </a:p>
        </p:txBody>
      </p:sp>
      <p:pic>
        <p:nvPicPr>
          <p:cNvPr id="103" name="Picture 102" descr="Chart&#10;&#10;Description automatically generated with medium confidence">
            <a:extLst>
              <a:ext uri="{FF2B5EF4-FFF2-40B4-BE49-F238E27FC236}">
                <a16:creationId xmlns:a16="http://schemas.microsoft.com/office/drawing/2014/main" id="{69C76608-74B5-44B1-B922-1BE67151B3B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23" t="5488" b="8047"/>
          <a:stretch/>
        </p:blipFill>
        <p:spPr>
          <a:xfrm>
            <a:off x="1813872" y="2301015"/>
            <a:ext cx="6103015" cy="193142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5E11FDA-129E-411E-834F-7D2F1390D37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13872" y="4565864"/>
            <a:ext cx="6103015" cy="1930232"/>
          </a:xfrm>
          <a:prstGeom prst="rect">
            <a:avLst/>
          </a:prstGeom>
        </p:spPr>
      </p:pic>
      <p:grpSp>
        <p:nvGrpSpPr>
          <p:cNvPr id="104" name="Group 103">
            <a:extLst>
              <a:ext uri="{FF2B5EF4-FFF2-40B4-BE49-F238E27FC236}">
                <a16:creationId xmlns:a16="http://schemas.microsoft.com/office/drawing/2014/main" id="{F6B01311-4552-4244-82DF-D39FF7B9172B}"/>
              </a:ext>
            </a:extLst>
          </p:cNvPr>
          <p:cNvGrpSpPr/>
          <p:nvPr/>
        </p:nvGrpSpPr>
        <p:grpSpPr>
          <a:xfrm>
            <a:off x="2269616" y="6450120"/>
            <a:ext cx="5315638" cy="215444"/>
            <a:chOff x="2275966" y="2002973"/>
            <a:chExt cx="5315638" cy="215444"/>
          </a:xfrm>
        </p:grpSpPr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A53BA0FD-6302-4F18-9378-AB2CA1119C2E}"/>
                </a:ext>
              </a:extLst>
            </p:cNvPr>
            <p:cNvSpPr txBox="1"/>
            <p:nvPr/>
          </p:nvSpPr>
          <p:spPr>
            <a:xfrm>
              <a:off x="2275966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982A68D7-8C6C-44F5-8B7C-1A7A4429C06E}"/>
                </a:ext>
              </a:extLst>
            </p:cNvPr>
            <p:cNvSpPr txBox="1"/>
            <p:nvPr/>
          </p:nvSpPr>
          <p:spPr>
            <a:xfrm>
              <a:off x="2826902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7D3CEF04-90EE-4431-9ECE-A768E2BF92EB}"/>
                </a:ext>
              </a:extLst>
            </p:cNvPr>
            <p:cNvSpPr txBox="1"/>
            <p:nvPr/>
          </p:nvSpPr>
          <p:spPr>
            <a:xfrm>
              <a:off x="326536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AC67D4FC-46D9-40EB-94EF-52F0DF3B0D83}"/>
                </a:ext>
              </a:extLst>
            </p:cNvPr>
            <p:cNvSpPr txBox="1"/>
            <p:nvPr/>
          </p:nvSpPr>
          <p:spPr>
            <a:xfrm>
              <a:off x="362913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D9F5D3D5-B9F1-4928-8E54-143289523E4C}"/>
                </a:ext>
              </a:extLst>
            </p:cNvPr>
            <p:cNvSpPr txBox="1"/>
            <p:nvPr/>
          </p:nvSpPr>
          <p:spPr>
            <a:xfrm>
              <a:off x="398853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1B4AB0E1-6C4E-4F41-B123-92044CC0B7A8}"/>
                </a:ext>
              </a:extLst>
            </p:cNvPr>
            <p:cNvSpPr txBox="1"/>
            <p:nvPr/>
          </p:nvSpPr>
          <p:spPr>
            <a:xfrm>
              <a:off x="4308020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1A209E4F-A53E-4FC9-9CDA-5F5EDAA921E9}"/>
                </a:ext>
              </a:extLst>
            </p:cNvPr>
            <p:cNvSpPr txBox="1"/>
            <p:nvPr/>
          </p:nvSpPr>
          <p:spPr>
            <a:xfrm>
              <a:off x="4595451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60D99A5E-73B7-4C4B-A3B5-BCAFC75847E1}"/>
                </a:ext>
              </a:extLst>
            </p:cNvPr>
            <p:cNvSpPr txBox="1"/>
            <p:nvPr/>
          </p:nvSpPr>
          <p:spPr>
            <a:xfrm>
              <a:off x="4868257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E1F6AF8D-9245-4D4C-A5B4-D363BCF1144B}"/>
                </a:ext>
              </a:extLst>
            </p:cNvPr>
            <p:cNvSpPr txBox="1"/>
            <p:nvPr/>
          </p:nvSpPr>
          <p:spPr>
            <a:xfrm>
              <a:off x="5123764" y="200297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EA6963A3-70DB-4302-A2DC-785D6CE6BCE6}"/>
                </a:ext>
              </a:extLst>
            </p:cNvPr>
            <p:cNvSpPr txBox="1"/>
            <p:nvPr/>
          </p:nvSpPr>
          <p:spPr>
            <a:xfrm>
              <a:off x="532681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E25E2865-AF34-4F96-B636-B93FA531A15A}"/>
                </a:ext>
              </a:extLst>
            </p:cNvPr>
            <p:cNvSpPr txBox="1"/>
            <p:nvPr/>
          </p:nvSpPr>
          <p:spPr>
            <a:xfrm>
              <a:off x="552433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D8E491EE-60EA-4951-BD9D-30ACA02DBD37}"/>
                </a:ext>
              </a:extLst>
            </p:cNvPr>
            <p:cNvSpPr txBox="1"/>
            <p:nvPr/>
          </p:nvSpPr>
          <p:spPr>
            <a:xfrm>
              <a:off x="5668627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DEBFB52A-8E2A-47EE-B97F-9ABECDC47F4D}"/>
                </a:ext>
              </a:extLst>
            </p:cNvPr>
            <p:cNvSpPr txBox="1"/>
            <p:nvPr/>
          </p:nvSpPr>
          <p:spPr>
            <a:xfrm>
              <a:off x="585909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8EF88D10-170D-4650-B272-70DCC962FE51}"/>
                </a:ext>
              </a:extLst>
            </p:cNvPr>
            <p:cNvSpPr txBox="1"/>
            <p:nvPr/>
          </p:nvSpPr>
          <p:spPr>
            <a:xfrm>
              <a:off x="606366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19482130-7CA9-4058-A089-FFDBE894895A}"/>
                </a:ext>
              </a:extLst>
            </p:cNvPr>
            <p:cNvSpPr txBox="1"/>
            <p:nvPr/>
          </p:nvSpPr>
          <p:spPr>
            <a:xfrm>
              <a:off x="6289689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E64757DF-D714-455F-8C99-C2E844E782C9}"/>
                </a:ext>
              </a:extLst>
            </p:cNvPr>
            <p:cNvSpPr txBox="1"/>
            <p:nvPr/>
          </p:nvSpPr>
          <p:spPr>
            <a:xfrm>
              <a:off x="6481592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17D33D1B-3ABC-481E-B2B8-999E887C02D1}"/>
                </a:ext>
              </a:extLst>
            </p:cNvPr>
            <p:cNvSpPr txBox="1"/>
            <p:nvPr/>
          </p:nvSpPr>
          <p:spPr>
            <a:xfrm>
              <a:off x="666324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E0D404EB-FF83-4E29-B763-7FD1949397C2}"/>
                </a:ext>
              </a:extLst>
            </p:cNvPr>
            <p:cNvSpPr txBox="1"/>
            <p:nvPr/>
          </p:nvSpPr>
          <p:spPr>
            <a:xfrm>
              <a:off x="683645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D720C1C9-0736-4A78-9C33-186E387AA139}"/>
                </a:ext>
              </a:extLst>
            </p:cNvPr>
            <p:cNvSpPr txBox="1"/>
            <p:nvPr/>
          </p:nvSpPr>
          <p:spPr>
            <a:xfrm>
              <a:off x="6986326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26C7E29C-C42E-4AEB-A5D9-DD96DB0AEF27}"/>
                </a:ext>
              </a:extLst>
            </p:cNvPr>
            <p:cNvSpPr txBox="1"/>
            <p:nvPr/>
          </p:nvSpPr>
          <p:spPr>
            <a:xfrm>
              <a:off x="7126160" y="2002973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4ADBCCC4-0564-4CB1-8F0E-C66549BDC92D}"/>
                </a:ext>
              </a:extLst>
            </p:cNvPr>
            <p:cNvSpPr txBox="1"/>
            <p:nvPr/>
          </p:nvSpPr>
          <p:spPr>
            <a:xfrm>
              <a:off x="7338008" y="2002973"/>
              <a:ext cx="2535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X</a:t>
              </a:r>
            </a:p>
          </p:txBody>
        </p:sp>
      </p:grp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E9FD0165-C38C-42DA-B92E-75714C7FFA3A}"/>
              </a:ext>
            </a:extLst>
          </p:cNvPr>
          <p:cNvGrpSpPr/>
          <p:nvPr/>
        </p:nvGrpSpPr>
        <p:grpSpPr>
          <a:xfrm>
            <a:off x="1106844" y="4428109"/>
            <a:ext cx="774589" cy="1756583"/>
            <a:chOff x="1106007" y="77696"/>
            <a:chExt cx="774589" cy="1756583"/>
          </a:xfrm>
        </p:grpSpPr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5FD46743-D821-4476-8D0B-A271958E694A}"/>
                </a:ext>
              </a:extLst>
            </p:cNvPr>
            <p:cNvSpPr txBox="1"/>
            <p:nvPr/>
          </p:nvSpPr>
          <p:spPr>
            <a:xfrm>
              <a:off x="1638222" y="1618835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014BE8A7-B77A-4EFE-8262-9DB9BBDD8033}"/>
                </a:ext>
              </a:extLst>
            </p:cNvPr>
            <p:cNvSpPr txBox="1"/>
            <p:nvPr/>
          </p:nvSpPr>
          <p:spPr>
            <a:xfrm>
              <a:off x="1638222" y="1075774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446455CB-A038-4A7C-988E-D2070756B143}"/>
                </a:ext>
              </a:extLst>
            </p:cNvPr>
            <p:cNvSpPr txBox="1"/>
            <p:nvPr/>
          </p:nvSpPr>
          <p:spPr>
            <a:xfrm>
              <a:off x="1638222" y="555437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A7781989-FDE2-49B2-896A-B9B8AB0E6441}"/>
                </a:ext>
              </a:extLst>
            </p:cNvPr>
            <p:cNvSpPr txBox="1"/>
            <p:nvPr/>
          </p:nvSpPr>
          <p:spPr>
            <a:xfrm rot="10800000">
              <a:off x="1277883" y="768481"/>
              <a:ext cx="353943" cy="818494"/>
            </a:xfrm>
            <a:prstGeom prst="rect">
              <a:avLst/>
            </a:prstGeom>
            <a:noFill/>
          </p:spPr>
          <p:txBody>
            <a:bodyPr vert="eaVert" wrap="none" rtlCol="0">
              <a:spAutoFit/>
            </a:bodyPr>
            <a:lstStyle/>
            <a:p>
              <a:r>
                <a:rPr lang="en-US" sz="1100" dirty="0"/>
                <a:t>-log(p-value)</a:t>
              </a:r>
            </a:p>
          </p:txBody>
        </p:sp>
        <p:sp>
          <p:nvSpPr>
            <p:cNvPr id="131" name="TextBox 130">
              <a:extLst>
                <a:ext uri="{FF2B5EF4-FFF2-40B4-BE49-F238E27FC236}">
                  <a16:creationId xmlns:a16="http://schemas.microsoft.com/office/drawing/2014/main" id="{2048F19E-6778-48D7-AF06-95FA422469A2}"/>
                </a:ext>
              </a:extLst>
            </p:cNvPr>
            <p:cNvSpPr txBox="1"/>
            <p:nvPr/>
          </p:nvSpPr>
          <p:spPr>
            <a:xfrm>
              <a:off x="1106007" y="77696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93675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0</TotalTime>
  <Words>282</Words>
  <Application>Microsoft Office PowerPoint</Application>
  <PresentationFormat>Letter Paper (8.5x11 in)</PresentationFormat>
  <Paragraphs>174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1_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u V Tran PhD</dc:creator>
  <cp:lastModifiedBy>Shirelle Liu</cp:lastModifiedBy>
  <cp:revision>2</cp:revision>
  <dcterms:created xsi:type="dcterms:W3CDTF">2021-08-30T19:47:45Z</dcterms:created>
  <dcterms:modified xsi:type="dcterms:W3CDTF">2022-06-07T14:57:33Z</dcterms:modified>
</cp:coreProperties>
</file>